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4"/>
  </p:sldMasterIdLst>
  <p:notesMasterIdLst>
    <p:notesMasterId r:id="rId10"/>
  </p:notesMasterIdLst>
  <p:sldIdLst>
    <p:sldId id="1540" r:id="rId5"/>
    <p:sldId id="1542" r:id="rId6"/>
    <p:sldId id="1543" r:id="rId7"/>
    <p:sldId id="1544" r:id="rId8"/>
    <p:sldId id="1545" r:id="rId9"/>
  </p:sldIdLst>
  <p:sldSz cx="31089600" cy="40233600"/>
  <p:notesSz cx="6858000" cy="9144000"/>
  <p:defaultTextStyle>
    <a:defPPr>
      <a:defRPr lang="en-US"/>
    </a:defPPr>
    <a:lvl1pPr marL="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1pPr>
    <a:lvl2pPr marL="18288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2pPr>
    <a:lvl3pPr marL="36576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3pPr>
    <a:lvl4pPr marL="54864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4pPr>
    <a:lvl5pPr marL="73152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5pPr>
    <a:lvl6pPr marL="91440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6pPr>
    <a:lvl7pPr marL="109728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7pPr>
    <a:lvl8pPr marL="128016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8pPr>
    <a:lvl9pPr marL="14630400" algn="l" defTabSz="1828800" rtl="0" eaLnBrk="1" latinLnBrk="0" hangingPunct="1">
      <a:defRPr sz="72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145AF66C-1F35-9EDF-602B-05FB60636AD2}" name="Brian J Bennett" initials="BJB" userId="S::bjbennett@ucdavis.edu::86264001-c59b-4a9c-9454-0e087f272703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yungsuk Kim" initials="MK" lastIdx="22" clrIdx="0">
    <p:extLst>
      <p:ext uri="{19B8F6BF-5375-455C-9EA6-DF929625EA0E}">
        <p15:presenceInfo xmlns:p15="http://schemas.microsoft.com/office/powerpoint/2012/main" userId="S::kmskim@ucdavis.edu::01c55adf-c7bb-4a84-bfaf-0a9e82040ff7" providerId="AD"/>
      </p:ext>
    </p:extLst>
  </p:cmAuthor>
  <p:cmAuthor id="2" name="Bennett, Brian - ARS" initials="BBA" lastIdx="2" clrIdx="1">
    <p:extLst>
      <p:ext uri="{19B8F6BF-5375-455C-9EA6-DF929625EA0E}">
        <p15:presenceInfo xmlns:p15="http://schemas.microsoft.com/office/powerpoint/2012/main" userId="S::brian.bennett@usda.gov::91e9d6a4-fe7b-41ce-b62f-da0470ad76bb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8F8F8"/>
    <a:srgbClr val="FF7DC1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226" autoAdjust="0"/>
    <p:restoredTop sz="88662" autoAdjust="0"/>
  </p:normalViewPr>
  <p:slideViewPr>
    <p:cSldViewPr snapToGrid="0">
      <p:cViewPr varScale="1">
        <p:scale>
          <a:sx n="17" d="100"/>
          <a:sy n="17" d="100"/>
        </p:scale>
        <p:origin x="141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23" d="100"/>
        <a:sy n="12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commentAuthors" Target="commentAuthors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userId="88e0d699a6b28b13" providerId="LiveId" clId="{1A945DDC-CFED-4AC5-8D6E-ED00658A14BE}"/>
    <pc:docChg chg="undo custSel modSld">
      <pc:chgData name="" userId="88e0d699a6b28b13" providerId="LiveId" clId="{1A945DDC-CFED-4AC5-8D6E-ED00658A14BE}" dt="2023-02-22T00:19:56.237" v="231" actId="1035"/>
      <pc:docMkLst>
        <pc:docMk/>
      </pc:docMkLst>
      <pc:sldChg chg="addSp modSp">
        <pc:chgData name="" userId="88e0d699a6b28b13" providerId="LiveId" clId="{1A945DDC-CFED-4AC5-8D6E-ED00658A14BE}" dt="2023-02-22T00:18:09.144" v="205" actId="20577"/>
        <pc:sldMkLst>
          <pc:docMk/>
          <pc:sldMk cId="1705390873" sldId="1542"/>
        </pc:sldMkLst>
        <pc:spChg chg="add">
          <ac:chgData name="" userId="88e0d699a6b28b13" providerId="LiveId" clId="{1A945DDC-CFED-4AC5-8D6E-ED00658A14BE}" dt="2023-02-22T00:17:43.321" v="193"/>
          <ac:spMkLst>
            <pc:docMk/>
            <pc:sldMk cId="1705390873" sldId="1542"/>
            <ac:spMk id="8" creationId="{ED687DF0-7C52-4D8E-A76C-05691B05F528}"/>
          </ac:spMkLst>
        </pc:spChg>
        <pc:spChg chg="add mod">
          <ac:chgData name="" userId="88e0d699a6b28b13" providerId="LiveId" clId="{1A945DDC-CFED-4AC5-8D6E-ED00658A14BE}" dt="2023-02-22T00:17:50.808" v="199" actId="20577"/>
          <ac:spMkLst>
            <pc:docMk/>
            <pc:sldMk cId="1705390873" sldId="1542"/>
            <ac:spMk id="10" creationId="{8BF4032D-E51D-410E-B2DC-17F1E78DB06F}"/>
          </ac:spMkLst>
        </pc:spChg>
        <pc:spChg chg="add mod">
          <ac:chgData name="" userId="88e0d699a6b28b13" providerId="LiveId" clId="{1A945DDC-CFED-4AC5-8D6E-ED00658A14BE}" dt="2023-02-22T00:18:06.844" v="203" actId="20577"/>
          <ac:spMkLst>
            <pc:docMk/>
            <pc:sldMk cId="1705390873" sldId="1542"/>
            <ac:spMk id="11" creationId="{AAF7CC9E-DA71-48EE-A725-F7CBB55ED9BB}"/>
          </ac:spMkLst>
        </pc:spChg>
        <pc:spChg chg="add mod">
          <ac:chgData name="" userId="88e0d699a6b28b13" providerId="LiveId" clId="{1A945DDC-CFED-4AC5-8D6E-ED00658A14BE}" dt="2023-02-22T00:18:09.144" v="205" actId="20577"/>
          <ac:spMkLst>
            <pc:docMk/>
            <pc:sldMk cId="1705390873" sldId="1542"/>
            <ac:spMk id="12" creationId="{FB0F7DBE-EA49-48FA-BA31-BC0740234FEF}"/>
          </ac:spMkLst>
        </pc:spChg>
        <pc:picChg chg="mod">
          <ac:chgData name="" userId="88e0d699a6b28b13" providerId="LiveId" clId="{1A945DDC-CFED-4AC5-8D6E-ED00658A14BE}" dt="2023-02-22T00:17:31.206" v="191" actId="1076"/>
          <ac:picMkLst>
            <pc:docMk/>
            <pc:sldMk cId="1705390873" sldId="1542"/>
            <ac:picMk id="3" creationId="{096DF978-8C53-45B0-A1E7-B7857A6FCF3D}"/>
          </ac:picMkLst>
        </pc:picChg>
        <pc:picChg chg="mod">
          <ac:chgData name="" userId="88e0d699a6b28b13" providerId="LiveId" clId="{1A945DDC-CFED-4AC5-8D6E-ED00658A14BE}" dt="2023-02-22T00:17:29.203" v="190" actId="1076"/>
          <ac:picMkLst>
            <pc:docMk/>
            <pc:sldMk cId="1705390873" sldId="1542"/>
            <ac:picMk id="7" creationId="{46F4AF2D-D3B5-49E0-9359-0E6DA862C8F8}"/>
          </ac:picMkLst>
        </pc:picChg>
        <pc:picChg chg="mod">
          <ac:chgData name="" userId="88e0d699a6b28b13" providerId="LiveId" clId="{1A945DDC-CFED-4AC5-8D6E-ED00658A14BE}" dt="2023-02-22T00:17:35.771" v="192" actId="1076"/>
          <ac:picMkLst>
            <pc:docMk/>
            <pc:sldMk cId="1705390873" sldId="1542"/>
            <ac:picMk id="9" creationId="{BD454621-5688-4E41-8479-AD9B0CEB0F24}"/>
          </ac:picMkLst>
        </pc:picChg>
      </pc:sldChg>
      <pc:sldChg chg="addSp modSp">
        <pc:chgData name="" userId="88e0d699a6b28b13" providerId="LiveId" clId="{1A945DDC-CFED-4AC5-8D6E-ED00658A14BE}" dt="2023-02-22T00:19:56.237" v="231" actId="1035"/>
        <pc:sldMkLst>
          <pc:docMk/>
          <pc:sldMk cId="910824263" sldId="1543"/>
        </pc:sldMkLst>
        <pc:spChg chg="add">
          <ac:chgData name="" userId="88e0d699a6b28b13" providerId="LiveId" clId="{1A945DDC-CFED-4AC5-8D6E-ED00658A14BE}" dt="2023-02-22T00:19:18.729" v="206"/>
          <ac:spMkLst>
            <pc:docMk/>
            <pc:sldMk cId="910824263" sldId="1543"/>
            <ac:spMk id="15" creationId="{D6A01F0A-69FA-4CFF-89E8-6756A467253C}"/>
          </ac:spMkLst>
        </pc:spChg>
        <pc:spChg chg="add mod">
          <ac:chgData name="" userId="88e0d699a6b28b13" providerId="LiveId" clId="{1A945DDC-CFED-4AC5-8D6E-ED00658A14BE}" dt="2023-02-22T00:19:29.281" v="210" actId="20577"/>
          <ac:spMkLst>
            <pc:docMk/>
            <pc:sldMk cId="910824263" sldId="1543"/>
            <ac:spMk id="27" creationId="{0694C4D6-3ED6-48A8-B649-2ADF7AB79183}"/>
          </ac:spMkLst>
        </pc:spChg>
        <pc:spChg chg="add mod">
          <ac:chgData name="" userId="88e0d699a6b28b13" providerId="LiveId" clId="{1A945DDC-CFED-4AC5-8D6E-ED00658A14BE}" dt="2023-02-22T00:19:50.353" v="223" actId="20577"/>
          <ac:spMkLst>
            <pc:docMk/>
            <pc:sldMk cId="910824263" sldId="1543"/>
            <ac:spMk id="28" creationId="{5FE98D26-ED87-415C-8716-CCBF0FF5D5A4}"/>
          </ac:spMkLst>
        </pc:spChg>
        <pc:spChg chg="add mod">
          <ac:chgData name="" userId="88e0d699a6b28b13" providerId="LiveId" clId="{1A945DDC-CFED-4AC5-8D6E-ED00658A14BE}" dt="2023-02-22T00:19:56.237" v="231" actId="1035"/>
          <ac:spMkLst>
            <pc:docMk/>
            <pc:sldMk cId="910824263" sldId="1543"/>
            <ac:spMk id="29" creationId="{34BCC1CD-123F-408D-A653-2715BE95579D}"/>
          </ac:spMkLst>
        </pc:sp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11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16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17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18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19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0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1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2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3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4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5" creationId="{00000000-0000-0000-0000-000000000000}"/>
          </ac:picMkLst>
        </pc:picChg>
        <pc:picChg chg="mod">
          <ac:chgData name="" userId="88e0d699a6b28b13" providerId="LiveId" clId="{1A945DDC-CFED-4AC5-8D6E-ED00658A14BE}" dt="2023-02-22T00:19:35.134" v="219" actId="1038"/>
          <ac:picMkLst>
            <pc:docMk/>
            <pc:sldMk cId="910824263" sldId="1543"/>
            <ac:picMk id="26" creationId="{00000000-0000-0000-0000-000000000000}"/>
          </ac:picMkLst>
        </pc:picChg>
      </pc:sldChg>
      <pc:sldChg chg="addSp delSp modSp">
        <pc:chgData name="" userId="88e0d699a6b28b13" providerId="LiveId" clId="{1A945DDC-CFED-4AC5-8D6E-ED00658A14BE}" dt="2023-02-14T01:45:36.063" v="186" actId="167"/>
        <pc:sldMkLst>
          <pc:docMk/>
          <pc:sldMk cId="3633656865" sldId="1544"/>
        </pc:sldMkLst>
        <pc:spChg chg="del">
          <ac:chgData name="" userId="88e0d699a6b28b13" providerId="LiveId" clId="{1A945DDC-CFED-4AC5-8D6E-ED00658A14BE}" dt="2023-02-14T01:39:47.221" v="1" actId="478"/>
          <ac:spMkLst>
            <pc:docMk/>
            <pc:sldMk cId="3633656865" sldId="1544"/>
            <ac:spMk id="2" creationId="{C39470B6-F959-7F3F-2E2C-E08D5CF0774B}"/>
          </ac:spMkLst>
        </pc:spChg>
        <pc:spChg chg="del">
          <ac:chgData name="" userId="88e0d699a6b28b13" providerId="LiveId" clId="{1A945DDC-CFED-4AC5-8D6E-ED00658A14BE}" dt="2023-02-14T01:41:49.556" v="21" actId="478"/>
          <ac:spMkLst>
            <pc:docMk/>
            <pc:sldMk cId="3633656865" sldId="1544"/>
            <ac:spMk id="3" creationId="{5C8628C9-06E4-69E2-D20A-7ED806A716D4}"/>
          </ac:spMkLst>
        </pc:spChg>
        <pc:spChg chg="add del">
          <ac:chgData name="" userId="88e0d699a6b28b13" providerId="LiveId" clId="{1A945DDC-CFED-4AC5-8D6E-ED00658A14BE}" dt="2023-02-14T01:39:52.338" v="6"/>
          <ac:spMkLst>
            <pc:docMk/>
            <pc:sldMk cId="3633656865" sldId="1544"/>
            <ac:spMk id="17" creationId="{629E4DCD-7ECE-493F-8E88-1E5BA0E5BE8D}"/>
          </ac:spMkLst>
        </pc:spChg>
        <pc:spChg chg="add del">
          <ac:chgData name="" userId="88e0d699a6b28b13" providerId="LiveId" clId="{1A945DDC-CFED-4AC5-8D6E-ED00658A14BE}" dt="2023-02-14T01:39:52.338" v="6"/>
          <ac:spMkLst>
            <pc:docMk/>
            <pc:sldMk cId="3633656865" sldId="1544"/>
            <ac:spMk id="18" creationId="{69319C0E-A817-4CED-A6C3-8CF6E0B7C3BD}"/>
          </ac:spMkLst>
        </pc:spChg>
        <pc:spChg chg="add mod">
          <ac:chgData name="" userId="88e0d699a6b28b13" providerId="LiveId" clId="{1A945DDC-CFED-4AC5-8D6E-ED00658A14BE}" dt="2023-02-14T01:40:03.166" v="12" actId="20577"/>
          <ac:spMkLst>
            <pc:docMk/>
            <pc:sldMk cId="3633656865" sldId="1544"/>
            <ac:spMk id="19" creationId="{ADFE543C-210D-4798-9EF4-2F01ACE9A9AF}"/>
          </ac:spMkLst>
        </pc:spChg>
        <pc:spChg chg="add mod">
          <ac:chgData name="" userId="88e0d699a6b28b13" providerId="LiveId" clId="{1A945DDC-CFED-4AC5-8D6E-ED00658A14BE}" dt="2023-02-14T01:40:05.487" v="14" actId="20577"/>
          <ac:spMkLst>
            <pc:docMk/>
            <pc:sldMk cId="3633656865" sldId="1544"/>
            <ac:spMk id="20" creationId="{DFB7D93F-A93D-4D2F-9227-983FDFC8C9F2}"/>
          </ac:spMkLst>
        </pc:spChg>
        <pc:grpChg chg="add mod ord">
          <ac:chgData name="" userId="88e0d699a6b28b13" providerId="LiveId" clId="{1A945DDC-CFED-4AC5-8D6E-ED00658A14BE}" dt="2023-02-14T01:45:36.063" v="186" actId="167"/>
          <ac:grpSpMkLst>
            <pc:docMk/>
            <pc:sldMk cId="3633656865" sldId="1544"/>
            <ac:grpSpMk id="14" creationId="{31CF41AB-910A-4F4E-AE00-14BECCE20850}"/>
          </ac:grpSpMkLst>
        </pc:grpChg>
        <pc:grpChg chg="add mod ord">
          <ac:chgData name="" userId="88e0d699a6b28b13" providerId="LiveId" clId="{1A945DDC-CFED-4AC5-8D6E-ED00658A14BE}" dt="2023-02-14T01:45:33.907" v="185" actId="167"/>
          <ac:grpSpMkLst>
            <pc:docMk/>
            <pc:sldMk cId="3633656865" sldId="1544"/>
            <ac:grpSpMk id="16" creationId="{E047B35C-B0ED-42E0-935C-AA5EBE8268D3}"/>
          </ac:grpSpMkLst>
        </pc:grpChg>
        <pc:picChg chg="add mod modCrop">
          <ac:chgData name="" userId="88e0d699a6b28b13" providerId="LiveId" clId="{1A945DDC-CFED-4AC5-8D6E-ED00658A14BE}" dt="2023-02-14T01:45:09.100" v="173" actId="164"/>
          <ac:picMkLst>
            <pc:docMk/>
            <pc:sldMk cId="3633656865" sldId="1544"/>
            <ac:picMk id="7" creationId="{29B39009-CC36-461E-A23D-27BD85F21E75}"/>
          </ac:picMkLst>
        </pc:picChg>
        <pc:picChg chg="add mod ord modCrop">
          <ac:chgData name="" userId="88e0d699a6b28b13" providerId="LiveId" clId="{1A945DDC-CFED-4AC5-8D6E-ED00658A14BE}" dt="2023-02-14T01:45:31.760" v="184" actId="164"/>
          <ac:picMkLst>
            <pc:docMk/>
            <pc:sldMk cId="3633656865" sldId="1544"/>
            <ac:picMk id="13" creationId="{F4D63BFD-AA45-4592-9D1C-6EC114E41F3E}"/>
          </ac:picMkLst>
        </pc:picChg>
        <pc:picChg chg="add mod modCrop">
          <ac:chgData name="" userId="88e0d699a6b28b13" providerId="LiveId" clId="{1A945DDC-CFED-4AC5-8D6E-ED00658A14BE}" dt="2023-02-14T01:45:09.100" v="173" actId="164"/>
          <ac:picMkLst>
            <pc:docMk/>
            <pc:sldMk cId="3633656865" sldId="1544"/>
            <ac:picMk id="23" creationId="{8635A417-ACD9-45C4-900F-4F60EB39A91D}"/>
          </ac:picMkLst>
        </pc:picChg>
        <pc:picChg chg="add mod modCrop">
          <ac:chgData name="" userId="88e0d699a6b28b13" providerId="LiveId" clId="{1A945DDC-CFED-4AC5-8D6E-ED00658A14BE}" dt="2023-02-14T01:45:31.760" v="184" actId="164"/>
          <ac:picMkLst>
            <pc:docMk/>
            <pc:sldMk cId="3633656865" sldId="1544"/>
            <ac:picMk id="26" creationId="{86166833-DBCA-4367-9A7E-C73C09F19945}"/>
          </ac:picMkLst>
        </pc:picChg>
        <pc:picChg chg="add mod">
          <ac:chgData name="" userId="88e0d699a6b28b13" providerId="LiveId" clId="{1A945DDC-CFED-4AC5-8D6E-ED00658A14BE}" dt="2023-02-14T01:45:09.100" v="173" actId="164"/>
          <ac:picMkLst>
            <pc:docMk/>
            <pc:sldMk cId="3633656865" sldId="1544"/>
            <ac:picMk id="27" creationId="{028D6D91-838D-48AC-A742-09DC31CBBC6B}"/>
          </ac:picMkLst>
        </pc:picChg>
        <pc:picChg chg="mod">
          <ac:chgData name="" userId="88e0d699a6b28b13" providerId="LiveId" clId="{1A945DDC-CFED-4AC5-8D6E-ED00658A14BE}" dt="2023-02-14T01:39:51.832" v="5" actId="1076"/>
          <ac:picMkLst>
            <pc:docMk/>
            <pc:sldMk cId="3633656865" sldId="1544"/>
            <ac:picMk id="29" creationId="{00000000-0000-0000-0000-000000000000}"/>
          </ac:picMkLst>
        </pc:picChg>
        <pc:picChg chg="add mod">
          <ac:chgData name="" userId="88e0d699a6b28b13" providerId="LiveId" clId="{1A945DDC-CFED-4AC5-8D6E-ED00658A14BE}" dt="2023-02-14T01:45:31.760" v="184" actId="164"/>
          <ac:picMkLst>
            <pc:docMk/>
            <pc:sldMk cId="3633656865" sldId="1544"/>
            <ac:picMk id="30" creationId="{690BB8CE-5C30-40CA-884E-7063A38364E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47B5CF-AD05-854E-B58A-EC75086F2F26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7BC788-3103-DD42-81FE-657C3AEF8F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57959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1pPr>
    <a:lvl2pPr marL="1901220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2pPr>
    <a:lvl3pPr marL="3802440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3pPr>
    <a:lvl4pPr marL="5703660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4pPr>
    <a:lvl5pPr marL="7604880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5pPr>
    <a:lvl6pPr marL="9506104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6pPr>
    <a:lvl7pPr marL="11407324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7pPr>
    <a:lvl8pPr marL="13308544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8pPr>
    <a:lvl9pPr marL="15209764" algn="l" defTabSz="3802440" rtl="0" eaLnBrk="1" latinLnBrk="0" hangingPunct="1">
      <a:defRPr sz="499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07317E-2412-469D-B9E2-03B1F386A3FE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5371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507317E-2412-469D-B9E2-03B1F386A3FE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030478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7BC788-3103-DD42-81FE-657C3AEF8F9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66907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7BC788-3103-DD42-81FE-657C3AEF8F9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378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31720" y="6584530"/>
            <a:ext cx="26426160" cy="14007253"/>
          </a:xfrm>
        </p:spPr>
        <p:txBody>
          <a:bodyPr anchor="b"/>
          <a:lstStyle>
            <a:lvl1pPr algn="ctr">
              <a:defRPr sz="20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86200" y="21131956"/>
            <a:ext cx="23317200" cy="9713804"/>
          </a:xfrm>
        </p:spPr>
        <p:txBody>
          <a:bodyPr/>
          <a:lstStyle>
            <a:lvl1pPr marL="0" indent="0" algn="ctr">
              <a:buNone/>
              <a:defRPr sz="8160"/>
            </a:lvl1pPr>
            <a:lvl2pPr marL="1554480" indent="0" algn="ctr">
              <a:buNone/>
              <a:defRPr sz="6800"/>
            </a:lvl2pPr>
            <a:lvl3pPr marL="3108960" indent="0" algn="ctr">
              <a:buNone/>
              <a:defRPr sz="6120"/>
            </a:lvl3pPr>
            <a:lvl4pPr marL="4663440" indent="0" algn="ctr">
              <a:buNone/>
              <a:defRPr sz="5440"/>
            </a:lvl4pPr>
            <a:lvl5pPr marL="6217920" indent="0" algn="ctr">
              <a:buNone/>
              <a:defRPr sz="5440"/>
            </a:lvl5pPr>
            <a:lvl6pPr marL="7772400" indent="0" algn="ctr">
              <a:buNone/>
              <a:defRPr sz="5440"/>
            </a:lvl6pPr>
            <a:lvl7pPr marL="9326880" indent="0" algn="ctr">
              <a:buNone/>
              <a:defRPr sz="5440"/>
            </a:lvl7pPr>
            <a:lvl8pPr marL="10881360" indent="0" algn="ctr">
              <a:buNone/>
              <a:defRPr sz="5440"/>
            </a:lvl8pPr>
            <a:lvl9pPr marL="12435840" indent="0" algn="ctr">
              <a:buNone/>
              <a:defRPr sz="544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5423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766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248497" y="2142067"/>
            <a:ext cx="6703695" cy="3409611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37412" y="2142067"/>
            <a:ext cx="19722465" cy="3409611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5149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6928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21219" y="10030472"/>
            <a:ext cx="26814780" cy="16736057"/>
          </a:xfrm>
        </p:spPr>
        <p:txBody>
          <a:bodyPr anchor="b"/>
          <a:lstStyle>
            <a:lvl1pPr>
              <a:defRPr sz="20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21219" y="26924858"/>
            <a:ext cx="26814780" cy="8801097"/>
          </a:xfrm>
        </p:spPr>
        <p:txBody>
          <a:bodyPr/>
          <a:lstStyle>
            <a:lvl1pPr marL="0" indent="0">
              <a:buNone/>
              <a:defRPr sz="8160">
                <a:solidFill>
                  <a:schemeClr val="tx1"/>
                </a:solidFill>
              </a:defRPr>
            </a:lvl1pPr>
            <a:lvl2pPr marL="1554480" indent="0">
              <a:buNone/>
              <a:defRPr sz="6800">
                <a:solidFill>
                  <a:schemeClr val="tx1">
                    <a:tint val="75000"/>
                  </a:schemeClr>
                </a:solidFill>
              </a:defRPr>
            </a:lvl2pPr>
            <a:lvl3pPr marL="3108960" indent="0">
              <a:buNone/>
              <a:defRPr sz="6120">
                <a:solidFill>
                  <a:schemeClr val="tx1">
                    <a:tint val="75000"/>
                  </a:schemeClr>
                </a:solidFill>
              </a:defRPr>
            </a:lvl3pPr>
            <a:lvl4pPr marL="466344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4pPr>
            <a:lvl5pPr marL="621792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5pPr>
            <a:lvl6pPr marL="777240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6pPr>
            <a:lvl7pPr marL="932688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7pPr>
            <a:lvl8pPr marL="1088136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8pPr>
            <a:lvl9pPr marL="12435840" indent="0">
              <a:buNone/>
              <a:defRPr sz="54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053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37410" y="10710333"/>
            <a:ext cx="13213080" cy="255278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739110" y="10710333"/>
            <a:ext cx="13213080" cy="255278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9008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59" y="2142076"/>
            <a:ext cx="26814780" cy="777663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41463" y="9862823"/>
            <a:ext cx="13152356" cy="4833617"/>
          </a:xfrm>
        </p:spPr>
        <p:txBody>
          <a:bodyPr anchor="b"/>
          <a:lstStyle>
            <a:lvl1pPr marL="0" indent="0">
              <a:buNone/>
              <a:defRPr sz="8160" b="1"/>
            </a:lvl1pPr>
            <a:lvl2pPr marL="1554480" indent="0">
              <a:buNone/>
              <a:defRPr sz="6800" b="1"/>
            </a:lvl2pPr>
            <a:lvl3pPr marL="3108960" indent="0">
              <a:buNone/>
              <a:defRPr sz="6120" b="1"/>
            </a:lvl3pPr>
            <a:lvl4pPr marL="4663440" indent="0">
              <a:buNone/>
              <a:defRPr sz="5440" b="1"/>
            </a:lvl4pPr>
            <a:lvl5pPr marL="6217920" indent="0">
              <a:buNone/>
              <a:defRPr sz="5440" b="1"/>
            </a:lvl5pPr>
            <a:lvl6pPr marL="7772400" indent="0">
              <a:buNone/>
              <a:defRPr sz="5440" b="1"/>
            </a:lvl6pPr>
            <a:lvl7pPr marL="9326880" indent="0">
              <a:buNone/>
              <a:defRPr sz="5440" b="1"/>
            </a:lvl7pPr>
            <a:lvl8pPr marL="10881360" indent="0">
              <a:buNone/>
              <a:defRPr sz="5440" b="1"/>
            </a:lvl8pPr>
            <a:lvl9pPr marL="12435840" indent="0">
              <a:buNone/>
              <a:defRPr sz="544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41463" y="14696440"/>
            <a:ext cx="13152356" cy="216162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739112" y="9862823"/>
            <a:ext cx="13217129" cy="4833617"/>
          </a:xfrm>
        </p:spPr>
        <p:txBody>
          <a:bodyPr anchor="b"/>
          <a:lstStyle>
            <a:lvl1pPr marL="0" indent="0">
              <a:buNone/>
              <a:defRPr sz="8160" b="1"/>
            </a:lvl1pPr>
            <a:lvl2pPr marL="1554480" indent="0">
              <a:buNone/>
              <a:defRPr sz="6800" b="1"/>
            </a:lvl2pPr>
            <a:lvl3pPr marL="3108960" indent="0">
              <a:buNone/>
              <a:defRPr sz="6120" b="1"/>
            </a:lvl3pPr>
            <a:lvl4pPr marL="4663440" indent="0">
              <a:buNone/>
              <a:defRPr sz="5440" b="1"/>
            </a:lvl4pPr>
            <a:lvl5pPr marL="6217920" indent="0">
              <a:buNone/>
              <a:defRPr sz="5440" b="1"/>
            </a:lvl5pPr>
            <a:lvl6pPr marL="7772400" indent="0">
              <a:buNone/>
              <a:defRPr sz="5440" b="1"/>
            </a:lvl6pPr>
            <a:lvl7pPr marL="9326880" indent="0">
              <a:buNone/>
              <a:defRPr sz="5440" b="1"/>
            </a:lvl7pPr>
            <a:lvl8pPr marL="10881360" indent="0">
              <a:buNone/>
              <a:defRPr sz="5440" b="1"/>
            </a:lvl8pPr>
            <a:lvl9pPr marL="12435840" indent="0">
              <a:buNone/>
              <a:defRPr sz="544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739112" y="14696440"/>
            <a:ext cx="13217129" cy="21616250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819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633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033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2682240"/>
            <a:ext cx="10027205" cy="9387840"/>
          </a:xfrm>
        </p:spPr>
        <p:txBody>
          <a:bodyPr anchor="b"/>
          <a:lstStyle>
            <a:lvl1pPr>
              <a:defRPr sz="108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217129" y="5792902"/>
            <a:ext cx="15739110" cy="28591933"/>
          </a:xfrm>
        </p:spPr>
        <p:txBody>
          <a:bodyPr/>
          <a:lstStyle>
            <a:lvl1pPr>
              <a:defRPr sz="10880"/>
            </a:lvl1pPr>
            <a:lvl2pPr>
              <a:defRPr sz="9520"/>
            </a:lvl2pPr>
            <a:lvl3pPr>
              <a:defRPr sz="8160"/>
            </a:lvl3pPr>
            <a:lvl4pPr>
              <a:defRPr sz="6800"/>
            </a:lvl4pPr>
            <a:lvl5pPr>
              <a:defRPr sz="6800"/>
            </a:lvl5pPr>
            <a:lvl6pPr>
              <a:defRPr sz="6800"/>
            </a:lvl6pPr>
            <a:lvl7pPr>
              <a:defRPr sz="6800"/>
            </a:lvl7pPr>
            <a:lvl8pPr>
              <a:defRPr sz="6800"/>
            </a:lvl8pPr>
            <a:lvl9pPr>
              <a:defRPr sz="6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12070080"/>
            <a:ext cx="10027205" cy="22361316"/>
          </a:xfrm>
        </p:spPr>
        <p:txBody>
          <a:bodyPr/>
          <a:lstStyle>
            <a:lvl1pPr marL="0" indent="0">
              <a:buNone/>
              <a:defRPr sz="5440"/>
            </a:lvl1pPr>
            <a:lvl2pPr marL="1554480" indent="0">
              <a:buNone/>
              <a:defRPr sz="4760"/>
            </a:lvl2pPr>
            <a:lvl3pPr marL="3108960" indent="0">
              <a:buNone/>
              <a:defRPr sz="4080"/>
            </a:lvl3pPr>
            <a:lvl4pPr marL="4663440" indent="0">
              <a:buNone/>
              <a:defRPr sz="3400"/>
            </a:lvl4pPr>
            <a:lvl5pPr marL="6217920" indent="0">
              <a:buNone/>
              <a:defRPr sz="3400"/>
            </a:lvl5pPr>
            <a:lvl6pPr marL="7772400" indent="0">
              <a:buNone/>
              <a:defRPr sz="3400"/>
            </a:lvl6pPr>
            <a:lvl7pPr marL="9326880" indent="0">
              <a:buNone/>
              <a:defRPr sz="3400"/>
            </a:lvl7pPr>
            <a:lvl8pPr marL="10881360" indent="0">
              <a:buNone/>
              <a:defRPr sz="3400"/>
            </a:lvl8pPr>
            <a:lvl9pPr marL="12435840" indent="0">
              <a:buNone/>
              <a:defRPr sz="34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759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41460" y="2682240"/>
            <a:ext cx="10027205" cy="9387840"/>
          </a:xfrm>
        </p:spPr>
        <p:txBody>
          <a:bodyPr anchor="b"/>
          <a:lstStyle>
            <a:lvl1pPr>
              <a:defRPr sz="1088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217129" y="5792902"/>
            <a:ext cx="15739110" cy="28591933"/>
          </a:xfrm>
        </p:spPr>
        <p:txBody>
          <a:bodyPr anchor="t"/>
          <a:lstStyle>
            <a:lvl1pPr marL="0" indent="0">
              <a:buNone/>
              <a:defRPr sz="10880"/>
            </a:lvl1pPr>
            <a:lvl2pPr marL="1554480" indent="0">
              <a:buNone/>
              <a:defRPr sz="9520"/>
            </a:lvl2pPr>
            <a:lvl3pPr marL="3108960" indent="0">
              <a:buNone/>
              <a:defRPr sz="8160"/>
            </a:lvl3pPr>
            <a:lvl4pPr marL="4663440" indent="0">
              <a:buNone/>
              <a:defRPr sz="6800"/>
            </a:lvl4pPr>
            <a:lvl5pPr marL="6217920" indent="0">
              <a:buNone/>
              <a:defRPr sz="6800"/>
            </a:lvl5pPr>
            <a:lvl6pPr marL="7772400" indent="0">
              <a:buNone/>
              <a:defRPr sz="6800"/>
            </a:lvl6pPr>
            <a:lvl7pPr marL="9326880" indent="0">
              <a:buNone/>
              <a:defRPr sz="6800"/>
            </a:lvl7pPr>
            <a:lvl8pPr marL="10881360" indent="0">
              <a:buNone/>
              <a:defRPr sz="6800"/>
            </a:lvl8pPr>
            <a:lvl9pPr marL="12435840" indent="0">
              <a:buNone/>
              <a:defRPr sz="68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41460" y="12070080"/>
            <a:ext cx="10027205" cy="22361316"/>
          </a:xfrm>
        </p:spPr>
        <p:txBody>
          <a:bodyPr/>
          <a:lstStyle>
            <a:lvl1pPr marL="0" indent="0">
              <a:buNone/>
              <a:defRPr sz="5440"/>
            </a:lvl1pPr>
            <a:lvl2pPr marL="1554480" indent="0">
              <a:buNone/>
              <a:defRPr sz="4760"/>
            </a:lvl2pPr>
            <a:lvl3pPr marL="3108960" indent="0">
              <a:buNone/>
              <a:defRPr sz="4080"/>
            </a:lvl3pPr>
            <a:lvl4pPr marL="4663440" indent="0">
              <a:buNone/>
              <a:defRPr sz="3400"/>
            </a:lvl4pPr>
            <a:lvl5pPr marL="6217920" indent="0">
              <a:buNone/>
              <a:defRPr sz="3400"/>
            </a:lvl5pPr>
            <a:lvl6pPr marL="7772400" indent="0">
              <a:buNone/>
              <a:defRPr sz="3400"/>
            </a:lvl6pPr>
            <a:lvl7pPr marL="9326880" indent="0">
              <a:buNone/>
              <a:defRPr sz="3400"/>
            </a:lvl7pPr>
            <a:lvl8pPr marL="10881360" indent="0">
              <a:buNone/>
              <a:defRPr sz="3400"/>
            </a:lvl8pPr>
            <a:lvl9pPr marL="12435840" indent="0">
              <a:buNone/>
              <a:defRPr sz="34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695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37410" y="2142076"/>
            <a:ext cx="26814780" cy="77766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37410" y="10710333"/>
            <a:ext cx="26814780" cy="255278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37410" y="37290595"/>
            <a:ext cx="6995160" cy="21420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A6153-B4BF-9745-AE42-D3230E499E5B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298430" y="37290595"/>
            <a:ext cx="10492740" cy="21420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957030" y="37290595"/>
            <a:ext cx="6995160" cy="21420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B97224-E179-F14D-8957-574370030D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580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108960" rtl="0" eaLnBrk="1" latinLnBrk="0" hangingPunct="1">
        <a:lnSpc>
          <a:spcPct val="90000"/>
        </a:lnSpc>
        <a:spcBef>
          <a:spcPct val="0"/>
        </a:spcBef>
        <a:buNone/>
        <a:defRPr sz="149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77240" indent="-777240" algn="l" defTabSz="3108960" rtl="0" eaLnBrk="1" latinLnBrk="0" hangingPunct="1">
        <a:lnSpc>
          <a:spcPct val="90000"/>
        </a:lnSpc>
        <a:spcBef>
          <a:spcPts val="3400"/>
        </a:spcBef>
        <a:buFont typeface="Arial" panose="020B0604020202020204" pitchFamily="34" charset="0"/>
        <a:buChar char="•"/>
        <a:defRPr sz="9520" kern="1200">
          <a:solidFill>
            <a:schemeClr val="tx1"/>
          </a:solidFill>
          <a:latin typeface="+mn-lt"/>
          <a:ea typeface="+mn-ea"/>
          <a:cs typeface="+mn-cs"/>
        </a:defRPr>
      </a:lvl1pPr>
      <a:lvl2pPr marL="233172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8160" kern="1200">
          <a:solidFill>
            <a:schemeClr val="tx1"/>
          </a:solidFill>
          <a:latin typeface="+mn-lt"/>
          <a:ea typeface="+mn-ea"/>
          <a:cs typeface="+mn-cs"/>
        </a:defRPr>
      </a:lvl2pPr>
      <a:lvl3pPr marL="388620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800" kern="1200">
          <a:solidFill>
            <a:schemeClr val="tx1"/>
          </a:solidFill>
          <a:latin typeface="+mn-lt"/>
          <a:ea typeface="+mn-ea"/>
          <a:cs typeface="+mn-cs"/>
        </a:defRPr>
      </a:lvl3pPr>
      <a:lvl4pPr marL="544068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4pPr>
      <a:lvl5pPr marL="699516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5pPr>
      <a:lvl6pPr marL="854964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6pPr>
      <a:lvl7pPr marL="1010412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7pPr>
      <a:lvl8pPr marL="1165860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8pPr>
      <a:lvl9pPr marL="13213080" indent="-777240" algn="l" defTabSz="3108960" rtl="0" eaLnBrk="1" latinLnBrk="0" hangingPunct="1">
        <a:lnSpc>
          <a:spcPct val="90000"/>
        </a:lnSpc>
        <a:spcBef>
          <a:spcPts val="1700"/>
        </a:spcBef>
        <a:buFont typeface="Arial" panose="020B0604020202020204" pitchFamily="34" charset="0"/>
        <a:buChar char="•"/>
        <a:defRPr sz="612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1pPr>
      <a:lvl2pPr marL="155448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2pPr>
      <a:lvl3pPr marL="310896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3pPr>
      <a:lvl4pPr marL="466344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4pPr>
      <a:lvl5pPr marL="621792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5pPr>
      <a:lvl6pPr marL="777240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6pPr>
      <a:lvl7pPr marL="932688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7pPr>
      <a:lvl8pPr marL="1088136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8pPr>
      <a:lvl9pPr marL="12435840" algn="l" defTabSz="3108960" rtl="0" eaLnBrk="1" latinLnBrk="0" hangingPunct="1">
        <a:defRPr sz="612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13" Type="http://schemas.openxmlformats.org/officeDocument/2006/relationships/image" Target="../media/image22.jpg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12" Type="http://schemas.openxmlformats.org/officeDocument/2006/relationships/image" Target="../media/image21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5.jpg"/><Relationship Id="rId11" Type="http://schemas.openxmlformats.org/officeDocument/2006/relationships/image" Target="../media/image20.jpg"/><Relationship Id="rId5" Type="http://schemas.openxmlformats.org/officeDocument/2006/relationships/image" Target="../media/image14.jpg"/><Relationship Id="rId10" Type="http://schemas.openxmlformats.org/officeDocument/2006/relationships/image" Target="../media/image19.jpg"/><Relationship Id="rId4" Type="http://schemas.openxmlformats.org/officeDocument/2006/relationships/image" Target="../media/image13.jpg"/><Relationship Id="rId9" Type="http://schemas.openxmlformats.org/officeDocument/2006/relationships/image" Target="../media/image18.jpg"/><Relationship Id="rId14" Type="http://schemas.openxmlformats.org/officeDocument/2006/relationships/image" Target="../media/image23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png"/><Relationship Id="rId9" Type="http://schemas.openxmlformats.org/officeDocument/2006/relationships/image" Target="../media/image3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565801" y="4466492"/>
            <a:ext cx="29855584" cy="14560062"/>
            <a:chOff x="565801" y="4466492"/>
            <a:chExt cx="29855584" cy="14560062"/>
          </a:xfrm>
        </p:grpSpPr>
        <p:grpSp>
          <p:nvGrpSpPr>
            <p:cNvPr id="105" name="Group 4"/>
            <p:cNvGrpSpPr/>
            <p:nvPr/>
          </p:nvGrpSpPr>
          <p:grpSpPr>
            <a:xfrm>
              <a:off x="13676994" y="8233204"/>
              <a:ext cx="884912" cy="2911381"/>
              <a:chOff x="4151403" y="2877132"/>
              <a:chExt cx="337744" cy="639951"/>
            </a:xfrm>
          </p:grpSpPr>
          <p:sp>
            <p:nvSpPr>
              <p:cNvPr id="106" name="Shape 470"/>
              <p:cNvSpPr/>
              <p:nvPr/>
            </p:nvSpPr>
            <p:spPr>
              <a:xfrm rot="16200000" flipH="1">
                <a:off x="4179868" y="3114411"/>
                <a:ext cx="546557" cy="72000"/>
              </a:xfrm>
              <a:prstGeom prst="rightArrow">
                <a:avLst>
                  <a:gd name="adj1" fmla="val 50000"/>
                  <a:gd name="adj2" fmla="val 50000"/>
                </a:avLst>
              </a:prstGeom>
              <a:solidFill>
                <a:sysClr val="windowText" lastClr="000000"/>
              </a:solidFill>
              <a:ln w="25400" cap="flat" cmpd="sng">
                <a:solidFill>
                  <a:sysClr val="windowText" lastClr="000000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44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  <p:sp>
            <p:nvSpPr>
              <p:cNvPr id="107" name="Shape 471"/>
              <p:cNvSpPr txBox="1"/>
              <p:nvPr/>
            </p:nvSpPr>
            <p:spPr>
              <a:xfrm rot="16200000">
                <a:off x="3976482" y="3095940"/>
                <a:ext cx="596064" cy="24622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2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16 weeks</a:t>
                </a:r>
                <a:endParaRPr kumimoji="0" sz="3200" b="1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</p:grpSp>
        <p:sp>
          <p:nvSpPr>
            <p:cNvPr id="108" name="Shape 481"/>
            <p:cNvSpPr/>
            <p:nvPr/>
          </p:nvSpPr>
          <p:spPr>
            <a:xfrm>
              <a:off x="3353824" y="11281153"/>
              <a:ext cx="4851495" cy="2141006"/>
            </a:xfrm>
            <a:prstGeom prst="rect">
              <a:avLst/>
            </a:prstGeom>
            <a:solidFill>
              <a:srgbClr val="E3DED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09" name="Shape 485"/>
            <p:cNvSpPr txBox="1"/>
            <p:nvPr/>
          </p:nvSpPr>
          <p:spPr>
            <a:xfrm>
              <a:off x="3179841" y="12014015"/>
              <a:ext cx="5103810" cy="11633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prstClr val="black"/>
                  </a:solidFill>
                  <a:latin typeface="Tahoma"/>
                  <a:ea typeface="Tahoma"/>
                  <a:cs typeface="Tahoma"/>
                  <a:sym typeface="Tahoma"/>
                </a:rPr>
                <a:t>Oil red O,</a:t>
              </a:r>
            </a:p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prstClr val="black"/>
                  </a:solidFill>
                  <a:latin typeface="Tahoma"/>
                  <a:ea typeface="Tahoma"/>
                  <a:cs typeface="Tahoma"/>
                  <a:sym typeface="Tahoma"/>
                </a:rPr>
                <a:t>Lesion circling</a:t>
              </a:r>
              <a:endParaRPr sz="3200" b="1" kern="0" dirty="0">
                <a:solidFill>
                  <a:prstClr val="black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0" name="Shape 500"/>
            <p:cNvSpPr txBox="1"/>
            <p:nvPr/>
          </p:nvSpPr>
          <p:spPr>
            <a:xfrm>
              <a:off x="9344306" y="11509725"/>
              <a:ext cx="3205422" cy="6979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Heart</a:t>
              </a:r>
              <a:endParaRPr sz="3200" b="1" kern="0" dirty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1" name="Shape 504"/>
            <p:cNvSpPr txBox="1"/>
            <p:nvPr/>
          </p:nvSpPr>
          <p:spPr>
            <a:xfrm>
              <a:off x="2977865" y="11437673"/>
              <a:ext cx="5376320" cy="77554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kern="0" dirty="0">
                  <a:solidFill>
                    <a:srgbClr val="FF0000"/>
                  </a:solidFill>
                  <a:latin typeface="Tahoma"/>
                  <a:ea typeface="Tahoma"/>
                  <a:cs typeface="Tahoma"/>
                  <a:sym typeface="Tahoma"/>
                </a:rPr>
                <a:t>Histological assay</a:t>
              </a:r>
              <a:endParaRPr sz="3600" b="1" kern="0" dirty="0">
                <a:solidFill>
                  <a:srgbClr val="FF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2" name="Shape 480"/>
            <p:cNvSpPr/>
            <p:nvPr/>
          </p:nvSpPr>
          <p:spPr>
            <a:xfrm>
              <a:off x="3476640" y="16397765"/>
              <a:ext cx="7435098" cy="2081014"/>
            </a:xfrm>
            <a:prstGeom prst="rect">
              <a:avLst/>
            </a:prstGeom>
            <a:solidFill>
              <a:srgbClr val="E3DED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3" name="Shape 482"/>
            <p:cNvSpPr/>
            <p:nvPr/>
          </p:nvSpPr>
          <p:spPr>
            <a:xfrm flipH="1">
              <a:off x="8320279" y="12294136"/>
              <a:ext cx="3852646" cy="177986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4" name="Shape 483"/>
            <p:cNvSpPr/>
            <p:nvPr/>
          </p:nvSpPr>
          <p:spPr>
            <a:xfrm rot="8648102">
              <a:off x="7654101" y="14858179"/>
              <a:ext cx="4873943" cy="14356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5" name="Shape 484"/>
            <p:cNvSpPr/>
            <p:nvPr/>
          </p:nvSpPr>
          <p:spPr>
            <a:xfrm rot="16200000" flipH="1">
              <a:off x="13113152" y="14933346"/>
              <a:ext cx="2630711" cy="119787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6" name="Shape 486"/>
            <p:cNvSpPr txBox="1"/>
            <p:nvPr/>
          </p:nvSpPr>
          <p:spPr>
            <a:xfrm rot="19531331">
              <a:off x="7610668" y="14136079"/>
              <a:ext cx="4676296" cy="6979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Plasma</a:t>
              </a:r>
              <a:endParaRPr sz="3200" b="1" kern="0" dirty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7" name="Shape 487"/>
            <p:cNvSpPr txBox="1"/>
            <p:nvPr/>
          </p:nvSpPr>
          <p:spPr>
            <a:xfrm>
              <a:off x="3420576" y="16511818"/>
              <a:ext cx="7508604" cy="742158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kern="0" dirty="0">
                  <a:solidFill>
                    <a:srgbClr val="FF0000"/>
                  </a:solidFill>
                  <a:latin typeface="Tahoma"/>
                  <a:ea typeface="Tahoma"/>
                  <a:cs typeface="Tahoma"/>
                  <a:sym typeface="Tahoma"/>
                </a:rPr>
                <a:t>Colorimetric assay</a:t>
              </a:r>
              <a:endParaRPr sz="3600" b="1" kern="0" dirty="0">
                <a:solidFill>
                  <a:srgbClr val="FF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18" name="Shape 488"/>
            <p:cNvSpPr/>
            <p:nvPr/>
          </p:nvSpPr>
          <p:spPr>
            <a:xfrm>
              <a:off x="4062526" y="17181886"/>
              <a:ext cx="6208745" cy="11633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prstClr val="black"/>
                  </a:solidFill>
                  <a:latin typeface="Tahoma"/>
                  <a:ea typeface="Tahoma"/>
                  <a:cs typeface="Tahoma"/>
                  <a:sym typeface="Tahoma"/>
                </a:rPr>
                <a:t>Total cholesterol, Triglyceride, Glucose</a:t>
              </a:r>
              <a:endParaRPr sz="3600" kern="0" dirty="0">
                <a:solidFill>
                  <a:prstClr val="black"/>
                </a:solidFill>
                <a:latin typeface="맑은 고딕"/>
                <a:cs typeface="Arial"/>
                <a:sym typeface="Arial"/>
              </a:endParaRPr>
            </a:p>
          </p:txBody>
        </p:sp>
        <p:grpSp>
          <p:nvGrpSpPr>
            <p:cNvPr id="119" name="Shape 489"/>
            <p:cNvGrpSpPr/>
            <p:nvPr/>
          </p:nvGrpSpPr>
          <p:grpSpPr>
            <a:xfrm>
              <a:off x="20665994" y="16085583"/>
              <a:ext cx="5827873" cy="2275160"/>
              <a:chOff x="6645165" y="5316030"/>
              <a:chExt cx="2224322" cy="854387"/>
            </a:xfrm>
          </p:grpSpPr>
          <p:sp>
            <p:nvSpPr>
              <p:cNvPr id="120" name="Shape 490"/>
              <p:cNvSpPr/>
              <p:nvPr/>
            </p:nvSpPr>
            <p:spPr>
              <a:xfrm>
                <a:off x="6758852" y="5412182"/>
                <a:ext cx="1973157" cy="758235"/>
              </a:xfrm>
              <a:prstGeom prst="rect">
                <a:avLst/>
              </a:prstGeom>
              <a:solidFill>
                <a:srgbClr val="E3DED1"/>
              </a:solidFill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44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  <p:sp>
            <p:nvSpPr>
              <p:cNvPr id="121" name="Shape 491"/>
              <p:cNvSpPr txBox="1"/>
              <p:nvPr/>
            </p:nvSpPr>
            <p:spPr>
              <a:xfrm>
                <a:off x="6895966" y="5316030"/>
                <a:ext cx="1722720" cy="52322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6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RNA sequencing</a:t>
                </a:r>
                <a:endParaRPr kumimoji="0" sz="3600" b="1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  <p:sp>
            <p:nvSpPr>
              <p:cNvPr id="122" name="Shape 492"/>
              <p:cNvSpPr/>
              <p:nvPr/>
            </p:nvSpPr>
            <p:spPr>
              <a:xfrm>
                <a:off x="6645165" y="5703007"/>
                <a:ext cx="222432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RNA extraction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200" b="1" i="0" u="none" strike="noStrike" kern="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eQTL</a:t>
                </a:r>
                <a:r>
                  <a:rPr kumimoji="0" lang="en-US" sz="3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 analysis</a:t>
                </a:r>
              </a:p>
            </p:txBody>
          </p:sp>
        </p:grpSp>
        <p:sp>
          <p:nvSpPr>
            <p:cNvPr id="123" name="Shape 493"/>
            <p:cNvSpPr/>
            <p:nvPr/>
          </p:nvSpPr>
          <p:spPr>
            <a:xfrm rot="1995399">
              <a:off x="16295819" y="14703381"/>
              <a:ext cx="4828226" cy="21983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24" name="Shape 497"/>
            <p:cNvSpPr/>
            <p:nvPr/>
          </p:nvSpPr>
          <p:spPr>
            <a:xfrm>
              <a:off x="12103159" y="16402299"/>
              <a:ext cx="4692551" cy="2076480"/>
            </a:xfrm>
            <a:prstGeom prst="rect">
              <a:avLst/>
            </a:prstGeom>
            <a:solidFill>
              <a:srgbClr val="E3DED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25" name="Shape 498"/>
            <p:cNvSpPr/>
            <p:nvPr/>
          </p:nvSpPr>
          <p:spPr>
            <a:xfrm>
              <a:off x="11890708" y="17420651"/>
              <a:ext cx="5284856" cy="11633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prstClr val="black"/>
                  </a:solidFill>
                  <a:latin typeface="Tahoma"/>
                  <a:ea typeface="Tahoma"/>
                  <a:cs typeface="Tahoma"/>
                  <a:sym typeface="Tahoma"/>
                </a:rPr>
                <a:t>Body weight</a:t>
              </a:r>
              <a:endParaRPr sz="3200" b="1" kern="0" dirty="0">
                <a:solidFill>
                  <a:prstClr val="black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26" name="Shape 499"/>
            <p:cNvSpPr txBox="1"/>
            <p:nvPr/>
          </p:nvSpPr>
          <p:spPr>
            <a:xfrm rot="16200000">
              <a:off x="12402447" y="14515663"/>
              <a:ext cx="3009418" cy="76818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Body</a:t>
              </a:r>
              <a:endParaRPr sz="3200" b="1" kern="0" dirty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27" name="Shape 501"/>
            <p:cNvSpPr txBox="1"/>
            <p:nvPr/>
          </p:nvSpPr>
          <p:spPr>
            <a:xfrm>
              <a:off x="11844977" y="16196685"/>
              <a:ext cx="5376320" cy="131843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kern="0" dirty="0">
                  <a:solidFill>
                    <a:srgbClr val="FF0000"/>
                  </a:solidFill>
                  <a:latin typeface="Tahoma"/>
                  <a:ea typeface="Tahoma"/>
                  <a:cs typeface="Tahoma"/>
                  <a:sym typeface="Tahoma"/>
                </a:rPr>
                <a:t>Clinical assay</a:t>
              </a:r>
              <a:endParaRPr sz="3600" b="1" kern="0" dirty="0">
                <a:solidFill>
                  <a:srgbClr val="FF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28" name="Shape 505"/>
            <p:cNvSpPr txBox="1"/>
            <p:nvPr/>
          </p:nvSpPr>
          <p:spPr>
            <a:xfrm rot="1981230">
              <a:off x="17326394" y="13960936"/>
              <a:ext cx="3205422" cy="6979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Liver</a:t>
              </a:r>
              <a:endParaRPr sz="3200" b="1" kern="0" dirty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grpSp>
          <p:nvGrpSpPr>
            <p:cNvPr id="129" name="Shape 489"/>
            <p:cNvGrpSpPr/>
            <p:nvPr/>
          </p:nvGrpSpPr>
          <p:grpSpPr>
            <a:xfrm>
              <a:off x="20687185" y="11166110"/>
              <a:ext cx="5827873" cy="2256049"/>
              <a:chOff x="6645165" y="5130407"/>
              <a:chExt cx="2224322" cy="895315"/>
            </a:xfrm>
          </p:grpSpPr>
          <p:sp>
            <p:nvSpPr>
              <p:cNvPr id="130" name="Shape 490"/>
              <p:cNvSpPr/>
              <p:nvPr/>
            </p:nvSpPr>
            <p:spPr>
              <a:xfrm>
                <a:off x="6760065" y="5220199"/>
                <a:ext cx="1965803" cy="805523"/>
              </a:xfrm>
              <a:prstGeom prst="rect">
                <a:avLst/>
              </a:prstGeom>
              <a:solidFill>
                <a:srgbClr val="E3DED1"/>
              </a:solidFill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endParaRPr kumimoji="0" sz="44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  <p:sp>
            <p:nvSpPr>
              <p:cNvPr id="131" name="Shape 491"/>
              <p:cNvSpPr txBox="1"/>
              <p:nvPr/>
            </p:nvSpPr>
            <p:spPr>
              <a:xfrm>
                <a:off x="6895966" y="5130407"/>
                <a:ext cx="1722720" cy="52322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600" b="1" i="0" u="none" strike="noStrike" kern="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Genotyping</a:t>
                </a:r>
                <a:endParaRPr kumimoji="0" sz="3600" b="1" i="0" u="none" strike="noStrike" kern="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Tahoma"/>
                  <a:ea typeface="Tahoma"/>
                  <a:cs typeface="Tahoma"/>
                  <a:sym typeface="Tahoma"/>
                </a:endParaRPr>
              </a:p>
            </p:txBody>
          </p:sp>
          <p:sp>
            <p:nvSpPr>
              <p:cNvPr id="132" name="Shape 492"/>
              <p:cNvSpPr/>
              <p:nvPr/>
            </p:nvSpPr>
            <p:spPr>
              <a:xfrm>
                <a:off x="6645165" y="5496400"/>
                <a:ext cx="2224322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QTL analysis for</a:t>
                </a:r>
              </a:p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>
                    <a:srgbClr val="000000"/>
                  </a:buClr>
                  <a:buSzTx/>
                  <a:buFont typeface="Arial"/>
                  <a:buNone/>
                  <a:tabLst/>
                  <a:defRPr/>
                </a:pPr>
                <a:r>
                  <a:rPr kumimoji="0" lang="en-US" sz="3200" b="1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Tahoma"/>
                    <a:ea typeface="Tahoma"/>
                    <a:cs typeface="Tahoma"/>
                    <a:sym typeface="Tahoma"/>
                  </a:rPr>
                  <a:t>traits and expression</a:t>
                </a:r>
              </a:p>
            </p:txBody>
          </p:sp>
        </p:grpSp>
        <p:sp>
          <p:nvSpPr>
            <p:cNvPr id="133" name="Shape 493"/>
            <p:cNvSpPr/>
            <p:nvPr/>
          </p:nvSpPr>
          <p:spPr>
            <a:xfrm>
              <a:off x="16601573" y="12277205"/>
              <a:ext cx="4017868" cy="18142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34" name="Shape 505"/>
            <p:cNvSpPr txBox="1"/>
            <p:nvPr/>
          </p:nvSpPr>
          <p:spPr>
            <a:xfrm>
              <a:off x="16991235" y="11520908"/>
              <a:ext cx="3205422" cy="6979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Tail</a:t>
              </a:r>
              <a:endParaRPr sz="3200" b="1" kern="0" dirty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35" name="Shape 482"/>
            <p:cNvSpPr/>
            <p:nvPr/>
          </p:nvSpPr>
          <p:spPr>
            <a:xfrm flipH="1">
              <a:off x="8320282" y="12294138"/>
              <a:ext cx="3852646" cy="18142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36" name="Shape 483"/>
            <p:cNvSpPr/>
            <p:nvPr/>
          </p:nvSpPr>
          <p:spPr>
            <a:xfrm rot="8648102">
              <a:off x="7642570" y="14823907"/>
              <a:ext cx="4873943" cy="181428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37" name="Shape 484"/>
            <p:cNvSpPr/>
            <p:nvPr/>
          </p:nvSpPr>
          <p:spPr>
            <a:xfrm rot="16200000" flipH="1">
              <a:off x="13147582" y="14898918"/>
              <a:ext cx="2630711" cy="188645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pic>
          <p:nvPicPr>
            <p:cNvPr id="138" name="그림 13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9" t="5237" r="73132" b="63272"/>
            <a:stretch/>
          </p:blipFill>
          <p:spPr>
            <a:xfrm>
              <a:off x="733243" y="11431807"/>
              <a:ext cx="2405266" cy="2025552"/>
            </a:xfrm>
            <a:prstGeom prst="rect">
              <a:avLst/>
            </a:prstGeom>
          </p:spPr>
        </p:pic>
        <p:pic>
          <p:nvPicPr>
            <p:cNvPr id="140" name="그림 139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054" t="18540" r="14514" b="68860"/>
            <a:stretch/>
          </p:blipFill>
          <p:spPr>
            <a:xfrm>
              <a:off x="565801" y="16394859"/>
              <a:ext cx="2872894" cy="1950347"/>
            </a:xfrm>
            <a:prstGeom prst="rect">
              <a:avLst/>
            </a:prstGeom>
          </p:spPr>
        </p:pic>
        <p:pic>
          <p:nvPicPr>
            <p:cNvPr id="141" name="그림 140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21" t="51050" r="19239" b="32150"/>
            <a:stretch/>
          </p:blipFill>
          <p:spPr>
            <a:xfrm>
              <a:off x="26309779" y="11594381"/>
              <a:ext cx="4111606" cy="1543149"/>
            </a:xfrm>
            <a:prstGeom prst="rect">
              <a:avLst/>
            </a:prstGeom>
          </p:spPr>
        </p:pic>
        <p:sp>
          <p:nvSpPr>
            <p:cNvPr id="142" name="Shape 464"/>
            <p:cNvSpPr txBox="1"/>
            <p:nvPr/>
          </p:nvSpPr>
          <p:spPr>
            <a:xfrm>
              <a:off x="9304012" y="6183117"/>
              <a:ext cx="3057050" cy="69799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dirty="0">
                  <a:solidFill>
                    <a:prstClr val="black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Acclimation</a:t>
              </a:r>
              <a:endParaRPr sz="3200" b="1" kern="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  <a:sym typeface="Tahoma"/>
              </a:endParaRPr>
            </a:p>
          </p:txBody>
        </p:sp>
        <p:sp>
          <p:nvSpPr>
            <p:cNvPr id="143" name="Shape 458"/>
            <p:cNvSpPr/>
            <p:nvPr/>
          </p:nvSpPr>
          <p:spPr>
            <a:xfrm>
              <a:off x="12449898" y="4543728"/>
              <a:ext cx="13212575" cy="3158028"/>
            </a:xfrm>
            <a:prstGeom prst="rect">
              <a:avLst/>
            </a:prstGeom>
            <a:solidFill>
              <a:srgbClr val="E3DED1"/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44" name="Shape 463"/>
            <p:cNvSpPr/>
            <p:nvPr/>
          </p:nvSpPr>
          <p:spPr>
            <a:xfrm>
              <a:off x="9150760" y="6839588"/>
              <a:ext cx="3112640" cy="115204"/>
            </a:xfrm>
            <a:prstGeom prst="rightArrow">
              <a:avLst>
                <a:gd name="adj1" fmla="val 50000"/>
                <a:gd name="adj2" fmla="val 50000"/>
              </a:avLst>
            </a:prstGeom>
            <a:solidFill>
              <a:sysClr val="windowText" lastClr="000000"/>
            </a:solidFill>
            <a:ln w="25400" cap="flat" cmpd="sng">
              <a:solidFill>
                <a:sysClr val="windowText" lastClr="000000"/>
              </a:solidFill>
              <a:prstDash val="solid"/>
              <a:round/>
              <a:headEnd type="none" w="sm" len="sm"/>
              <a:tailEnd type="none" w="sm" len="sm"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Tx/>
                <a:buFont typeface="Arial"/>
                <a:buNone/>
                <a:tabLst/>
                <a:defRPr/>
              </a:pPr>
              <a:endParaRPr kumimoji="0" sz="44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45" name="Shape 465"/>
            <p:cNvSpPr txBox="1"/>
            <p:nvPr/>
          </p:nvSpPr>
          <p:spPr>
            <a:xfrm>
              <a:off x="9691890" y="6963493"/>
              <a:ext cx="2291841" cy="702496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2 week</a:t>
              </a:r>
              <a:endParaRPr sz="3200" b="1" kern="0">
                <a:solidFill>
                  <a:srgbClr val="000000"/>
                </a:solidFill>
                <a:latin typeface="Tahoma"/>
                <a:ea typeface="Tahoma"/>
                <a:cs typeface="Tahoma"/>
                <a:sym typeface="Tahoma"/>
              </a:endParaRPr>
            </a:p>
          </p:txBody>
        </p:sp>
        <p:sp>
          <p:nvSpPr>
            <p:cNvPr id="146" name="Shape 468"/>
            <p:cNvSpPr txBox="1"/>
            <p:nvPr/>
          </p:nvSpPr>
          <p:spPr>
            <a:xfrm>
              <a:off x="15820811" y="5033912"/>
              <a:ext cx="10293165" cy="162865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High fat High cholesterol </a:t>
              </a:r>
            </a:p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(40 kcal% Fat [Cocoa Butter], </a:t>
              </a:r>
            </a:p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1.25% Cholesterol, 40 kcal% Carb, </a:t>
              </a:r>
            </a:p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200" b="1" kern="0" dirty="0">
                  <a:solidFill>
                    <a:srgbClr val="000000"/>
                  </a:solidFill>
                  <a:latin typeface="Tahoma"/>
                  <a:ea typeface="Tahoma"/>
                  <a:cs typeface="Tahoma"/>
                  <a:sym typeface="Tahoma"/>
                </a:rPr>
                <a:t>20 kcal% Protein from Research Diet)</a:t>
              </a:r>
            </a:p>
          </p:txBody>
        </p:sp>
        <p:sp>
          <p:nvSpPr>
            <p:cNvPr id="147" name="Shape 462"/>
            <p:cNvSpPr txBox="1"/>
            <p:nvPr/>
          </p:nvSpPr>
          <p:spPr>
            <a:xfrm>
              <a:off x="1245189" y="8166776"/>
              <a:ext cx="7751833" cy="116332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i="0" u="none" strike="noStrike" dirty="0">
                  <a:solidFill>
                    <a:srgbClr val="000000"/>
                  </a:solidFill>
                  <a:effectLst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(J:DO x CETP/ApoE3Leiden)-F1</a:t>
              </a:r>
              <a:r>
                <a:rPr lang="en-US" sz="3600" b="1" kern="0" dirty="0">
                  <a:solidFill>
                    <a:srgbClr val="000000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  <a:sym typeface="Tahoma"/>
                </a:rPr>
                <a:t> 238 females and 234 males</a:t>
              </a:r>
            </a:p>
            <a:p>
              <a:pPr algn="ctr" defTabSz="914400">
                <a:buClr>
                  <a:srgbClr val="000000"/>
                </a:buClr>
                <a:buFont typeface="Arial"/>
                <a:buNone/>
              </a:pPr>
              <a:r>
                <a:rPr lang="en-US" sz="3600" b="1" kern="0" dirty="0">
                  <a:solidFill>
                    <a:srgbClr val="000000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  <a:sym typeface="Tahoma"/>
                </a:rPr>
                <a:t>(6 weeks of age)</a:t>
              </a:r>
              <a:endParaRPr lang="en-US" sz="3600" b="1" kern="0" dirty="0">
                <a:solidFill>
                  <a:srgbClr val="FF0000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  <a:sym typeface="Tahoma"/>
              </a:endParaRPr>
            </a:p>
          </p:txBody>
        </p:sp>
        <p:pic>
          <p:nvPicPr>
            <p:cNvPr id="148" name="그림 147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738" t="12275" r="46802" b="71005"/>
            <a:stretch/>
          </p:blipFill>
          <p:spPr>
            <a:xfrm>
              <a:off x="1245189" y="6019174"/>
              <a:ext cx="3978365" cy="2050964"/>
            </a:xfrm>
            <a:prstGeom prst="rect">
              <a:avLst/>
            </a:prstGeom>
          </p:spPr>
        </p:pic>
        <p:pic>
          <p:nvPicPr>
            <p:cNvPr id="149" name="그림 148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36" t="16400" r="53076" b="58400"/>
            <a:stretch/>
          </p:blipFill>
          <p:spPr>
            <a:xfrm>
              <a:off x="12378268" y="10899843"/>
              <a:ext cx="3980689" cy="2625195"/>
            </a:xfrm>
            <a:prstGeom prst="rect">
              <a:avLst/>
            </a:prstGeom>
          </p:spPr>
        </p:pic>
        <p:pic>
          <p:nvPicPr>
            <p:cNvPr id="150" name="그림 149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35" t="16400" r="72850" b="58400"/>
            <a:stretch/>
          </p:blipFill>
          <p:spPr>
            <a:xfrm>
              <a:off x="2403444" y="4471071"/>
              <a:ext cx="1201807" cy="1765071"/>
            </a:xfrm>
            <a:prstGeom prst="rect">
              <a:avLst/>
            </a:prstGeom>
          </p:spPr>
        </p:pic>
        <p:pic>
          <p:nvPicPr>
            <p:cNvPr id="151" name="그림 15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045" t="12275" r="12157" b="71005"/>
            <a:stretch/>
          </p:blipFill>
          <p:spPr>
            <a:xfrm>
              <a:off x="4844055" y="6009757"/>
              <a:ext cx="4152966" cy="2050964"/>
            </a:xfrm>
            <a:prstGeom prst="rect">
              <a:avLst/>
            </a:prstGeom>
          </p:spPr>
        </p:pic>
        <p:pic>
          <p:nvPicPr>
            <p:cNvPr id="152" name="그림 151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904" t="16400" r="53076" b="58400"/>
            <a:stretch/>
          </p:blipFill>
          <p:spPr>
            <a:xfrm>
              <a:off x="6174015" y="4466492"/>
              <a:ext cx="1493043" cy="1765071"/>
            </a:xfrm>
            <a:prstGeom prst="rect">
              <a:avLst/>
            </a:prstGeom>
          </p:spPr>
        </p:pic>
        <p:pic>
          <p:nvPicPr>
            <p:cNvPr id="153" name="그림 152"/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94" t="37400" r="31544" b="37401"/>
            <a:stretch/>
          </p:blipFill>
          <p:spPr>
            <a:xfrm>
              <a:off x="12706450" y="4689155"/>
              <a:ext cx="4118164" cy="2795735"/>
            </a:xfrm>
            <a:prstGeom prst="rect">
              <a:avLst/>
            </a:prstGeom>
          </p:spPr>
        </p:pic>
        <p:pic>
          <p:nvPicPr>
            <p:cNvPr id="155" name="그림 154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978" t="7343" r="2696" b="60793"/>
            <a:stretch/>
          </p:blipFill>
          <p:spPr>
            <a:xfrm>
              <a:off x="26133666" y="16225141"/>
              <a:ext cx="3961982" cy="2801413"/>
            </a:xfrm>
            <a:prstGeom prst="rect">
              <a:avLst/>
            </a:prstGeom>
          </p:spPr>
        </p:pic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2" y="-155100"/>
            <a:ext cx="7641484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0" b="1" dirty="0"/>
              <a:t>Figure S1</a:t>
            </a:r>
          </a:p>
        </p:txBody>
      </p:sp>
      <p:sp>
        <p:nvSpPr>
          <p:cNvPr id="103" name="타원 102">
            <a:extLst>
              <a:ext uri="{FF2B5EF4-FFF2-40B4-BE49-F238E27FC236}">
                <a16:creationId xmlns:a16="http://schemas.microsoft.com/office/drawing/2014/main" id="{7EF2971E-FCDA-46D9-A5C3-20AC36FED857}"/>
              </a:ext>
            </a:extLst>
          </p:cNvPr>
          <p:cNvSpPr/>
          <p:nvPr/>
        </p:nvSpPr>
        <p:spPr>
          <a:xfrm>
            <a:off x="11449440" y="21663037"/>
            <a:ext cx="6985226" cy="1509275"/>
          </a:xfrm>
          <a:prstGeom prst="ellipse">
            <a:avLst/>
          </a:prstGeom>
          <a:gradFill rotWithShape="1">
            <a:gsLst>
              <a:gs pos="0">
                <a:sysClr val="windowText" lastClr="000000">
                  <a:tint val="50000"/>
                  <a:satMod val="300000"/>
                </a:sysClr>
              </a:gs>
              <a:gs pos="35000">
                <a:sysClr val="windowText" lastClr="000000">
                  <a:tint val="37000"/>
                  <a:satMod val="300000"/>
                </a:sysClr>
              </a:gs>
              <a:gs pos="100000">
                <a:sysClr val="windowText" lastClr="000000">
                  <a:tint val="15000"/>
                  <a:satMod val="350000"/>
                </a:sysClr>
              </a:gs>
            </a:gsLst>
            <a:lin ang="16200000" scaled="1"/>
          </a:gradFill>
          <a:ln w="9525" cap="flat" cmpd="sng" algn="ctr">
            <a:solidFill>
              <a:sysClr val="windowText" lastClr="000000">
                <a:shade val="95000"/>
                <a:satMod val="105000"/>
              </a:sys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599A3843-B898-4B26-B113-CFCD5B2545F2}"/>
              </a:ext>
            </a:extLst>
          </p:cNvPr>
          <p:cNvSpPr txBox="1"/>
          <p:nvPr/>
        </p:nvSpPr>
        <p:spPr>
          <a:xfrm>
            <a:off x="12156151" y="21973620"/>
            <a:ext cx="5962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472 (</a:t>
            </a:r>
            <a:r>
              <a:rPr lang="en-US" sz="3600" b="1" i="0" u="none" strike="noStrike" dirty="0">
                <a:solidFill>
                  <a:srgbClr val="000000"/>
                </a:solidFill>
                <a:effectLst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J:DO x CETP/ApoE3Leiden)-F1</a:t>
            </a:r>
            <a:r>
              <a:rPr kumimoji="0" lang="en-US" altLang="ko-KR" sz="3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mice</a:t>
            </a: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</a:endParaRPr>
          </a:p>
        </p:txBody>
      </p:sp>
      <p:sp>
        <p:nvSpPr>
          <p:cNvPr id="157" name="타원 156">
            <a:extLst>
              <a:ext uri="{FF2B5EF4-FFF2-40B4-BE49-F238E27FC236}">
                <a16:creationId xmlns:a16="http://schemas.microsoft.com/office/drawing/2014/main" id="{6D49F284-8155-4C27-B39D-FD346260472A}"/>
              </a:ext>
            </a:extLst>
          </p:cNvPr>
          <p:cNvSpPr/>
          <p:nvPr/>
        </p:nvSpPr>
        <p:spPr>
          <a:xfrm>
            <a:off x="20059038" y="23651882"/>
            <a:ext cx="6985226" cy="1839283"/>
          </a:xfrm>
          <a:prstGeom prst="ellipse">
            <a:avLst/>
          </a:prstGeom>
          <a:gradFill rotWithShape="1">
            <a:gsLst>
              <a:gs pos="0">
                <a:srgbClr val="1B587C">
                  <a:tint val="50000"/>
                  <a:satMod val="300000"/>
                </a:srgbClr>
              </a:gs>
              <a:gs pos="35000">
                <a:srgbClr val="1B587C">
                  <a:tint val="37000"/>
                  <a:satMod val="300000"/>
                </a:srgbClr>
              </a:gs>
              <a:gs pos="100000">
                <a:srgbClr val="1B587C">
                  <a:tint val="15000"/>
                  <a:satMod val="350000"/>
                </a:srgbClr>
              </a:gs>
            </a:gsLst>
            <a:lin ang="16200000" scaled="1"/>
          </a:gradFill>
          <a:ln w="9525" cap="flat" cmpd="sng" algn="ctr">
            <a:solidFill>
              <a:srgbClr val="1B587C">
                <a:shade val="95000"/>
                <a:satMod val="105000"/>
              </a:srgb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AF28C3B8-14FA-449C-8301-DD998A1D3D99}"/>
              </a:ext>
            </a:extLst>
          </p:cNvPr>
          <p:cNvSpPr txBox="1"/>
          <p:nvPr/>
        </p:nvSpPr>
        <p:spPr>
          <a:xfrm>
            <a:off x="20687185" y="24050912"/>
            <a:ext cx="5962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6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Liver Transcriptome</a:t>
            </a:r>
            <a:r>
              <a:rPr kumimoji="0" lang="en-US" sz="3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</a:t>
            </a:r>
          </a:p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3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data by RNA-</a:t>
            </a:r>
            <a:r>
              <a:rPr kumimoji="0" lang="en-US" sz="3600" b="0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eq</a:t>
            </a: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</a:endParaRPr>
          </a:p>
        </p:txBody>
      </p:sp>
      <p:sp>
        <p:nvSpPr>
          <p:cNvPr id="159" name="타원 158">
            <a:extLst>
              <a:ext uri="{FF2B5EF4-FFF2-40B4-BE49-F238E27FC236}">
                <a16:creationId xmlns:a16="http://schemas.microsoft.com/office/drawing/2014/main" id="{91AC229E-1D1F-4068-9BC4-7A6572F6A88D}"/>
              </a:ext>
            </a:extLst>
          </p:cNvPr>
          <p:cNvSpPr/>
          <p:nvPr/>
        </p:nvSpPr>
        <p:spPr>
          <a:xfrm>
            <a:off x="3234371" y="23609204"/>
            <a:ext cx="6985226" cy="1890763"/>
          </a:xfrm>
          <a:prstGeom prst="ellipse">
            <a:avLst/>
          </a:prstGeom>
          <a:gradFill rotWithShape="1">
            <a:gsLst>
              <a:gs pos="0">
                <a:srgbClr val="F07F09">
                  <a:tint val="50000"/>
                  <a:satMod val="300000"/>
                </a:srgbClr>
              </a:gs>
              <a:gs pos="35000">
                <a:srgbClr val="F07F09">
                  <a:tint val="37000"/>
                  <a:satMod val="300000"/>
                </a:srgbClr>
              </a:gs>
              <a:gs pos="100000">
                <a:srgbClr val="F07F09">
                  <a:tint val="15000"/>
                  <a:satMod val="350000"/>
                </a:srgbClr>
              </a:gs>
            </a:gsLst>
            <a:lin ang="16200000" scaled="1"/>
          </a:gradFill>
          <a:ln w="9525" cap="flat" cmpd="sng" algn="ctr">
            <a:solidFill>
              <a:srgbClr val="F07F09">
                <a:shade val="95000"/>
                <a:satMod val="105000"/>
              </a:srgb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F35DAF7C-EE12-4380-8516-2B31754754EC}"/>
              </a:ext>
            </a:extLst>
          </p:cNvPr>
          <p:cNvSpPr txBox="1"/>
          <p:nvPr/>
        </p:nvSpPr>
        <p:spPr>
          <a:xfrm>
            <a:off x="3530649" y="24039780"/>
            <a:ext cx="64465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 defTabSz="914400" latinLnBrk="1">
              <a:defRPr/>
            </a:pPr>
            <a:r>
              <a:rPr lang="en-US" altLang="ko-KR" sz="3600" b="1" kern="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henotyping</a:t>
            </a:r>
            <a:r>
              <a:rPr lang="en-US" altLang="ko-KR" sz="3600" kern="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 associated with </a:t>
            </a:r>
          </a:p>
          <a:p>
            <a:pPr lvl="0" algn="ctr" defTabSz="914400" latinLnBrk="1">
              <a:defRPr/>
            </a:pPr>
            <a:r>
              <a:rPr lang="en-US" altLang="ko-KR" sz="3600" kern="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therosclerosis</a:t>
            </a:r>
            <a:endParaRPr lang="en-US" altLang="ko-KR" sz="3600" kern="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161" name="아래쪽 화살표 121">
            <a:extLst>
              <a:ext uri="{FF2B5EF4-FFF2-40B4-BE49-F238E27FC236}">
                <a16:creationId xmlns:a16="http://schemas.microsoft.com/office/drawing/2014/main" id="{6CA069CE-BDC9-44F9-B9A0-E8DF6C0B0018}"/>
              </a:ext>
            </a:extLst>
          </p:cNvPr>
          <p:cNvSpPr/>
          <p:nvPr/>
        </p:nvSpPr>
        <p:spPr>
          <a:xfrm rot="2903448">
            <a:off x="9995771" y="22868900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62" name="아래쪽 화살표 122">
            <a:extLst>
              <a:ext uri="{FF2B5EF4-FFF2-40B4-BE49-F238E27FC236}">
                <a16:creationId xmlns:a16="http://schemas.microsoft.com/office/drawing/2014/main" id="{455C3B47-0AC5-4FA6-82BE-30E2D92607BC}"/>
              </a:ext>
            </a:extLst>
          </p:cNvPr>
          <p:cNvSpPr/>
          <p:nvPr/>
        </p:nvSpPr>
        <p:spPr>
          <a:xfrm rot="18807132">
            <a:off x="19381591" y="22875546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63" name="타원 162">
            <a:extLst>
              <a:ext uri="{FF2B5EF4-FFF2-40B4-BE49-F238E27FC236}">
                <a16:creationId xmlns:a16="http://schemas.microsoft.com/office/drawing/2014/main" id="{33D58D69-E8DA-4D2E-A34C-DD810D6AB042}"/>
              </a:ext>
            </a:extLst>
          </p:cNvPr>
          <p:cNvSpPr/>
          <p:nvPr/>
        </p:nvSpPr>
        <p:spPr>
          <a:xfrm>
            <a:off x="11449440" y="26262101"/>
            <a:ext cx="6985226" cy="1509276"/>
          </a:xfrm>
          <a:prstGeom prst="ellipse">
            <a:avLst/>
          </a:prstGeom>
          <a:gradFill rotWithShape="1">
            <a:gsLst>
              <a:gs pos="0">
                <a:srgbClr val="9F2936">
                  <a:tint val="50000"/>
                  <a:satMod val="300000"/>
                </a:srgbClr>
              </a:gs>
              <a:gs pos="35000">
                <a:srgbClr val="9F2936">
                  <a:tint val="37000"/>
                  <a:satMod val="300000"/>
                </a:srgbClr>
              </a:gs>
              <a:gs pos="100000">
                <a:srgbClr val="9F2936">
                  <a:tint val="15000"/>
                  <a:satMod val="350000"/>
                </a:srgbClr>
              </a:gs>
            </a:gsLst>
            <a:lin ang="16200000" scaled="1"/>
          </a:gradFill>
          <a:ln w="9525" cap="flat" cmpd="sng" algn="ctr">
            <a:solidFill>
              <a:srgbClr val="9F2936">
                <a:shade val="95000"/>
                <a:satMod val="105000"/>
              </a:srgbClr>
            </a:solidFill>
            <a:prstDash val="solid"/>
          </a:ln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3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33E899D8-568A-4882-A169-E759D701371D}"/>
              </a:ext>
            </a:extLst>
          </p:cNvPr>
          <p:cNvSpPr txBox="1"/>
          <p:nvPr/>
        </p:nvSpPr>
        <p:spPr>
          <a:xfrm>
            <a:off x="12064655" y="26382958"/>
            <a:ext cx="5962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 latinLnBrk="1"/>
            <a:r>
              <a:rPr lang="en-US" sz="3600" b="1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SNP genotyping </a:t>
            </a:r>
            <a:r>
              <a:rPr lang="en-US" sz="360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nd </a:t>
            </a:r>
          </a:p>
          <a:p>
            <a:pPr algn="ctr" defTabSz="914400" latinLnBrk="1"/>
            <a:r>
              <a:rPr lang="en-US" sz="3600" b="1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QTL analysis </a:t>
            </a:r>
            <a:r>
              <a:rPr lang="en-US" sz="360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(R/QTL2)</a:t>
            </a:r>
            <a:endParaRPr lang="en-US" sz="3600" dirty="0">
              <a:solidFill>
                <a:prstClr val="black"/>
              </a:solidFill>
              <a:latin typeface="맑은 고딕"/>
            </a:endParaRPr>
          </a:p>
        </p:txBody>
      </p:sp>
      <p:sp>
        <p:nvSpPr>
          <p:cNvPr id="166" name="아래쪽 화살표 139">
            <a:extLst>
              <a:ext uri="{FF2B5EF4-FFF2-40B4-BE49-F238E27FC236}">
                <a16:creationId xmlns:a16="http://schemas.microsoft.com/office/drawing/2014/main" id="{AD8B565B-0807-498D-A627-61DA733178F1}"/>
              </a:ext>
            </a:extLst>
          </p:cNvPr>
          <p:cNvSpPr/>
          <p:nvPr/>
        </p:nvSpPr>
        <p:spPr>
          <a:xfrm rot="18807132">
            <a:off x="10443180" y="25306001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67" name="아래쪽 화살표 140">
            <a:extLst>
              <a:ext uri="{FF2B5EF4-FFF2-40B4-BE49-F238E27FC236}">
                <a16:creationId xmlns:a16="http://schemas.microsoft.com/office/drawing/2014/main" id="{03F8BCF4-2B0F-4609-A225-26B055F81236}"/>
              </a:ext>
            </a:extLst>
          </p:cNvPr>
          <p:cNvSpPr/>
          <p:nvPr/>
        </p:nvSpPr>
        <p:spPr>
          <a:xfrm rot="2903448">
            <a:off x="19026336" y="25312648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007266A3-8964-4C51-82DC-59520022412A}"/>
              </a:ext>
            </a:extLst>
          </p:cNvPr>
          <p:cNvGrpSpPr/>
          <p:nvPr/>
        </p:nvGrpSpPr>
        <p:grpSpPr>
          <a:xfrm>
            <a:off x="5819739" y="30149145"/>
            <a:ext cx="8699731" cy="5135916"/>
            <a:chOff x="11788478" y="28613798"/>
            <a:chExt cx="6114339" cy="3583461"/>
          </a:xfrm>
        </p:grpSpPr>
        <p:grpSp>
          <p:nvGrpSpPr>
            <p:cNvPr id="173" name="그룹 172">
              <a:extLst>
                <a:ext uri="{FF2B5EF4-FFF2-40B4-BE49-F238E27FC236}">
                  <a16:creationId xmlns:a16="http://schemas.microsoft.com/office/drawing/2014/main" id="{D59B00E8-20CE-4DB4-A3D5-DB7D70D117C6}"/>
                </a:ext>
              </a:extLst>
            </p:cNvPr>
            <p:cNvGrpSpPr/>
            <p:nvPr/>
          </p:nvGrpSpPr>
          <p:grpSpPr>
            <a:xfrm>
              <a:off x="14200111" y="28613798"/>
              <a:ext cx="3702706" cy="3567507"/>
              <a:chOff x="5405147" y="3717368"/>
              <a:chExt cx="1396371" cy="1361655"/>
            </a:xfrm>
          </p:grpSpPr>
          <p:sp>
            <p:nvSpPr>
              <p:cNvPr id="174" name="타원 173">
                <a:extLst>
                  <a:ext uri="{FF2B5EF4-FFF2-40B4-BE49-F238E27FC236}">
                    <a16:creationId xmlns:a16="http://schemas.microsoft.com/office/drawing/2014/main" id="{97429276-E68A-4192-A08D-E13AAFA01C9E}"/>
                  </a:ext>
                </a:extLst>
              </p:cNvPr>
              <p:cNvSpPr/>
              <p:nvPr/>
            </p:nvSpPr>
            <p:spPr>
              <a:xfrm>
                <a:off x="5405147" y="3717368"/>
                <a:ext cx="1396371" cy="1361655"/>
              </a:xfrm>
              <a:prstGeom prst="ellipse">
                <a:avLst/>
              </a:prstGeom>
              <a:solidFill>
                <a:schemeClr val="accent1">
                  <a:alpha val="30000"/>
                </a:scheme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4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5" name="직사각형 174">
                <a:extLst>
                  <a:ext uri="{FF2B5EF4-FFF2-40B4-BE49-F238E27FC236}">
                    <a16:creationId xmlns:a16="http://schemas.microsoft.com/office/drawing/2014/main" id="{F9EF55CE-76D8-4F71-9AD8-5C4D57584795}"/>
                  </a:ext>
                </a:extLst>
              </p:cNvPr>
              <p:cNvSpPr/>
              <p:nvPr/>
            </p:nvSpPr>
            <p:spPr>
              <a:xfrm>
                <a:off x="5928584" y="4090608"/>
                <a:ext cx="812444" cy="6147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4800" b="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Liver</a:t>
                </a:r>
              </a:p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e</a:t>
                </a:r>
                <a:r>
                  <a:rPr kumimoji="0" lang="en-US" sz="4800" b="0" i="0" u="none" strike="noStrike" kern="0" cap="none" spc="0" normalizeH="0" baseline="0" noProof="0" dirty="0" err="1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xpression</a:t>
                </a:r>
                <a:endParaRPr kumimoji="0" lang="en-US" sz="4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4800" b="0" i="0" u="none" strike="noStrike" kern="0" cap="none" spc="0" normalizeH="0" baseline="0" noProof="0" dirty="0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QTL</a:t>
                </a:r>
              </a:p>
            </p:txBody>
          </p:sp>
        </p:grpSp>
        <p:grpSp>
          <p:nvGrpSpPr>
            <p:cNvPr id="177" name="그룹 176">
              <a:extLst>
                <a:ext uri="{FF2B5EF4-FFF2-40B4-BE49-F238E27FC236}">
                  <a16:creationId xmlns:a16="http://schemas.microsoft.com/office/drawing/2014/main" id="{01A19656-A053-4992-B393-0664DFF8265A}"/>
                </a:ext>
              </a:extLst>
            </p:cNvPr>
            <p:cNvGrpSpPr/>
            <p:nvPr/>
          </p:nvGrpSpPr>
          <p:grpSpPr>
            <a:xfrm>
              <a:off x="11788478" y="28629752"/>
              <a:ext cx="3702707" cy="3567507"/>
              <a:chOff x="4495667" y="3723458"/>
              <a:chExt cx="1396371" cy="1361655"/>
            </a:xfrm>
          </p:grpSpPr>
          <p:sp>
            <p:nvSpPr>
              <p:cNvPr id="178" name="타원 177">
                <a:extLst>
                  <a:ext uri="{FF2B5EF4-FFF2-40B4-BE49-F238E27FC236}">
                    <a16:creationId xmlns:a16="http://schemas.microsoft.com/office/drawing/2014/main" id="{B833710E-E86D-4CA6-9879-AB70871A84F9}"/>
                  </a:ext>
                </a:extLst>
              </p:cNvPr>
              <p:cNvSpPr/>
              <p:nvPr/>
            </p:nvSpPr>
            <p:spPr>
              <a:xfrm>
                <a:off x="4495667" y="3723458"/>
                <a:ext cx="1396371" cy="1361655"/>
              </a:xfrm>
              <a:prstGeom prst="ellipse">
                <a:avLst/>
              </a:prstGeom>
              <a:solidFill>
                <a:schemeClr val="accent2">
                  <a:alpha val="30000"/>
                </a:scheme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4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79" name="직사각형 178">
                <a:extLst>
                  <a:ext uri="{FF2B5EF4-FFF2-40B4-BE49-F238E27FC236}">
                    <a16:creationId xmlns:a16="http://schemas.microsoft.com/office/drawing/2014/main" id="{4D1E0E06-EDD3-45C8-AA4B-F1536B5D627F}"/>
                  </a:ext>
                </a:extLst>
              </p:cNvPr>
              <p:cNvSpPr/>
              <p:nvPr/>
            </p:nvSpPr>
            <p:spPr>
              <a:xfrm>
                <a:off x="4692966" y="4103855"/>
                <a:ext cx="584711" cy="61472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defTabSz="457200">
                  <a:defRPr/>
                </a:pPr>
                <a:r>
                  <a:rPr lang="en-US" altLang="ko-KR" sz="4800" kern="0" dirty="0" err="1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Athero</a:t>
                </a:r>
                <a:r>
                  <a:rPr lang="en-US" altLang="ko-KR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-</a:t>
                </a:r>
              </a:p>
              <a:p>
                <a:pPr lvl="0" algn="ctr" defTabSz="457200">
                  <a:defRPr/>
                </a:pPr>
                <a:r>
                  <a:rPr lang="en-US" altLang="ko-KR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traits</a:t>
                </a:r>
              </a:p>
              <a:p>
                <a:pPr lvl="0" algn="ctr" defTabSz="457200">
                  <a:defRPr/>
                </a:pPr>
                <a:r>
                  <a:rPr lang="en-US" altLang="ko-KR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QTL</a:t>
                </a:r>
              </a:p>
            </p:txBody>
          </p:sp>
        </p:grpSp>
      </p:grpSp>
      <p:grpSp>
        <p:nvGrpSpPr>
          <p:cNvPr id="181" name="그룹 180">
            <a:extLst>
              <a:ext uri="{FF2B5EF4-FFF2-40B4-BE49-F238E27FC236}">
                <a16:creationId xmlns:a16="http://schemas.microsoft.com/office/drawing/2014/main" id="{989A7195-27A8-4688-85F5-7B606C0FAFE2}"/>
              </a:ext>
            </a:extLst>
          </p:cNvPr>
          <p:cNvGrpSpPr/>
          <p:nvPr/>
        </p:nvGrpSpPr>
        <p:grpSpPr>
          <a:xfrm>
            <a:off x="11463427" y="36365786"/>
            <a:ext cx="6985226" cy="2929966"/>
            <a:chOff x="4367808" y="5974752"/>
            <a:chExt cx="2634280" cy="1118317"/>
          </a:xfrm>
        </p:grpSpPr>
        <p:sp>
          <p:nvSpPr>
            <p:cNvPr id="182" name="타원 181">
              <a:extLst>
                <a:ext uri="{FF2B5EF4-FFF2-40B4-BE49-F238E27FC236}">
                  <a16:creationId xmlns:a16="http://schemas.microsoft.com/office/drawing/2014/main" id="{6672C7F9-81AF-4D61-829E-4EB16E9D0D68}"/>
                </a:ext>
              </a:extLst>
            </p:cNvPr>
            <p:cNvSpPr/>
            <p:nvPr/>
          </p:nvSpPr>
          <p:spPr>
            <a:xfrm>
              <a:off x="4367808" y="5974752"/>
              <a:ext cx="2634280" cy="1118317"/>
            </a:xfrm>
            <a:prstGeom prst="ellipse">
              <a:avLst/>
            </a:prstGeom>
            <a:solidFill>
              <a:schemeClr val="accent6">
                <a:lumMod val="20000"/>
                <a:lumOff val="80000"/>
              </a:schemeClr>
            </a:solidFill>
            <a:ln w="9525" cap="flat" cmpd="sng" algn="ctr">
              <a:solidFill>
                <a:schemeClr val="accent6"/>
              </a:solidFill>
              <a:prstDash val="solid"/>
            </a:ln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txBody>
            <a:bodyPr rtlCol="0" anchor="ctr"/>
            <a:lstStyle/>
            <a:p>
              <a:pPr marL="0" marR="0" lvl="0" indent="0" algn="ct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36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endParaRPr>
            </a:p>
          </p:txBody>
        </p:sp>
        <p:sp>
          <p:nvSpPr>
            <p:cNvPr id="183" name="TextBox 182">
              <a:extLst>
                <a:ext uri="{FF2B5EF4-FFF2-40B4-BE49-F238E27FC236}">
                  <a16:creationId xmlns:a16="http://schemas.microsoft.com/office/drawing/2014/main" id="{B27AD5B0-1148-4503-AED1-FC253B18A01C}"/>
                </a:ext>
              </a:extLst>
            </p:cNvPr>
            <p:cNvSpPr txBox="1"/>
            <p:nvPr/>
          </p:nvSpPr>
          <p:spPr>
            <a:xfrm>
              <a:off x="4490892" y="6088468"/>
              <a:ext cx="2456079" cy="8105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Find candidate </a:t>
              </a:r>
            </a:p>
            <a:p>
              <a:pPr marL="0" marR="0" lvl="0" indent="0" algn="ctr" defTabSz="914400" eaLnBrk="1" fontAlgn="auto" latinLnBrk="1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lang="en-US" sz="4400" b="1" kern="0" dirty="0">
                  <a:solidFill>
                    <a:prstClr val="black"/>
                  </a:solidFill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g</a:t>
              </a:r>
              <a:r>
                <a:rPr kumimoji="0" lang="en-US" sz="4400" b="1" i="0" u="none" strike="noStrike" kern="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enes</a:t>
              </a:r>
              <a:r>
                <a:rPr kumimoji="0" lang="en-US" sz="4400" b="1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rPr>
                <a:t> associated with atherosclerosis</a:t>
              </a:r>
              <a:endParaRPr kumimoji="0" 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맑은 고딕"/>
              </a:endParaRPr>
            </a:p>
          </p:txBody>
        </p:sp>
      </p:grpSp>
      <p:sp>
        <p:nvSpPr>
          <p:cNvPr id="185" name="TextBox 184">
            <a:extLst>
              <a:ext uri="{FF2B5EF4-FFF2-40B4-BE49-F238E27FC236}">
                <a16:creationId xmlns:a16="http://schemas.microsoft.com/office/drawing/2014/main" id="{5F122900-D53D-47EA-B0D8-C99A2588EA9E}"/>
              </a:ext>
            </a:extLst>
          </p:cNvPr>
          <p:cNvSpPr txBox="1"/>
          <p:nvPr/>
        </p:nvSpPr>
        <p:spPr>
          <a:xfrm>
            <a:off x="443348" y="3071242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A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C420066B-4ADC-49CE-BDB7-AACD99E8A31F}"/>
              </a:ext>
            </a:extLst>
          </p:cNvPr>
          <p:cNvSpPr txBox="1"/>
          <p:nvPr/>
        </p:nvSpPr>
        <p:spPr>
          <a:xfrm>
            <a:off x="246537" y="20586359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B</a:t>
            </a:r>
          </a:p>
        </p:txBody>
      </p:sp>
      <p:sp>
        <p:nvSpPr>
          <p:cNvPr id="187" name="아래쪽 화살표 121">
            <a:extLst>
              <a:ext uri="{FF2B5EF4-FFF2-40B4-BE49-F238E27FC236}">
                <a16:creationId xmlns:a16="http://schemas.microsoft.com/office/drawing/2014/main" id="{8D01E22D-2307-4CCC-A4D3-C19F9778E4B4}"/>
              </a:ext>
            </a:extLst>
          </p:cNvPr>
          <p:cNvSpPr/>
          <p:nvPr/>
        </p:nvSpPr>
        <p:spPr>
          <a:xfrm rot="2903448">
            <a:off x="9916573" y="27756648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88" name="아래쪽 화살표 122">
            <a:extLst>
              <a:ext uri="{FF2B5EF4-FFF2-40B4-BE49-F238E27FC236}">
                <a16:creationId xmlns:a16="http://schemas.microsoft.com/office/drawing/2014/main" id="{7DAF6BAC-6FF6-43F7-B398-97538EB3192C}"/>
              </a:ext>
            </a:extLst>
          </p:cNvPr>
          <p:cNvSpPr/>
          <p:nvPr/>
        </p:nvSpPr>
        <p:spPr>
          <a:xfrm rot="18807132">
            <a:off x="19593494" y="27768868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89" name="아래쪽 화살표 139">
            <a:extLst>
              <a:ext uri="{FF2B5EF4-FFF2-40B4-BE49-F238E27FC236}">
                <a16:creationId xmlns:a16="http://schemas.microsoft.com/office/drawing/2014/main" id="{4D50AB7D-400C-4CF6-8047-BFBF7F658413}"/>
              </a:ext>
            </a:extLst>
          </p:cNvPr>
          <p:cNvSpPr/>
          <p:nvPr/>
        </p:nvSpPr>
        <p:spPr>
          <a:xfrm rot="18807132">
            <a:off x="10720025" y="35422244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sp>
        <p:nvSpPr>
          <p:cNvPr id="190" name="아래쪽 화살표 140">
            <a:extLst>
              <a:ext uri="{FF2B5EF4-FFF2-40B4-BE49-F238E27FC236}">
                <a16:creationId xmlns:a16="http://schemas.microsoft.com/office/drawing/2014/main" id="{3A38C3D7-F7C9-49AB-B77F-D172BD3DDC2E}"/>
              </a:ext>
            </a:extLst>
          </p:cNvPr>
          <p:cNvSpPr/>
          <p:nvPr/>
        </p:nvSpPr>
        <p:spPr>
          <a:xfrm rot="2903448">
            <a:off x="19081016" y="35412343"/>
            <a:ext cx="565978" cy="1080000"/>
          </a:xfrm>
          <a:prstGeom prst="downArrow">
            <a:avLst/>
          </a:prstGeom>
          <a:gradFill flip="none" rotWithShape="1">
            <a:gsLst>
              <a:gs pos="0">
                <a:sysClr val="window" lastClr="FFFFFF">
                  <a:lumMod val="75000"/>
                  <a:tint val="66000"/>
                  <a:satMod val="160000"/>
                </a:sysClr>
              </a:gs>
              <a:gs pos="50000">
                <a:sysClr val="window" lastClr="FFFFFF">
                  <a:lumMod val="75000"/>
                  <a:tint val="44500"/>
                  <a:satMod val="160000"/>
                </a:sysClr>
              </a:gs>
              <a:gs pos="100000">
                <a:sysClr val="window" lastClr="FFFFFF">
                  <a:lumMod val="75000"/>
                  <a:tint val="23500"/>
                  <a:satMod val="160000"/>
                </a:sysClr>
              </a:gs>
            </a:gsLst>
            <a:lin ang="2700000" scaled="1"/>
            <a:tileRect/>
          </a:gradFill>
          <a:ln w="25400" cap="flat" cmpd="sng" algn="ctr">
            <a:noFill/>
            <a:prstDash val="solid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맑은 고딕"/>
              <a:ea typeface="+mn-ea"/>
              <a:cs typeface="+mn-cs"/>
            </a:endParaRPr>
          </a:p>
        </p:txBody>
      </p:sp>
      <p:grpSp>
        <p:nvGrpSpPr>
          <p:cNvPr id="191" name="그룹 190">
            <a:extLst>
              <a:ext uri="{FF2B5EF4-FFF2-40B4-BE49-F238E27FC236}">
                <a16:creationId xmlns:a16="http://schemas.microsoft.com/office/drawing/2014/main" id="{8183347A-F88E-4B49-99C1-BB79C0C50EC3}"/>
              </a:ext>
            </a:extLst>
          </p:cNvPr>
          <p:cNvGrpSpPr/>
          <p:nvPr/>
        </p:nvGrpSpPr>
        <p:grpSpPr>
          <a:xfrm>
            <a:off x="18119150" y="30504753"/>
            <a:ext cx="6123899" cy="3458213"/>
            <a:chOff x="11788478" y="28613798"/>
            <a:chExt cx="6114339" cy="3583461"/>
          </a:xfrm>
        </p:grpSpPr>
        <p:grpSp>
          <p:nvGrpSpPr>
            <p:cNvPr id="192" name="그룹 191">
              <a:extLst>
                <a:ext uri="{FF2B5EF4-FFF2-40B4-BE49-F238E27FC236}">
                  <a16:creationId xmlns:a16="http://schemas.microsoft.com/office/drawing/2014/main" id="{F8D1BD48-9AEB-4D26-BB97-4071EEECF346}"/>
                </a:ext>
              </a:extLst>
            </p:cNvPr>
            <p:cNvGrpSpPr/>
            <p:nvPr/>
          </p:nvGrpSpPr>
          <p:grpSpPr>
            <a:xfrm>
              <a:off x="14200111" y="28613798"/>
              <a:ext cx="3702706" cy="3567507"/>
              <a:chOff x="5405147" y="3717368"/>
              <a:chExt cx="1396371" cy="1361655"/>
            </a:xfrm>
          </p:grpSpPr>
          <p:sp>
            <p:nvSpPr>
              <p:cNvPr id="196" name="타원 195">
                <a:extLst>
                  <a:ext uri="{FF2B5EF4-FFF2-40B4-BE49-F238E27FC236}">
                    <a16:creationId xmlns:a16="http://schemas.microsoft.com/office/drawing/2014/main" id="{E6A45D63-3025-46F6-8FB5-56606C505B1E}"/>
                  </a:ext>
                </a:extLst>
              </p:cNvPr>
              <p:cNvSpPr/>
              <p:nvPr/>
            </p:nvSpPr>
            <p:spPr>
              <a:xfrm>
                <a:off x="5405147" y="3717368"/>
                <a:ext cx="1396371" cy="1361655"/>
              </a:xfrm>
              <a:prstGeom prst="ellipse">
                <a:avLst/>
              </a:prstGeom>
              <a:solidFill>
                <a:srgbClr val="FFFF00">
                  <a:alpha val="30000"/>
                </a:srgb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480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97" name="직사각형 196">
                <a:extLst>
                  <a:ext uri="{FF2B5EF4-FFF2-40B4-BE49-F238E27FC236}">
                    <a16:creationId xmlns:a16="http://schemas.microsoft.com/office/drawing/2014/main" id="{1F281407-4AF7-4593-8F24-7521CC87545E}"/>
                  </a:ext>
                </a:extLst>
              </p:cNvPr>
              <p:cNvSpPr/>
              <p:nvPr/>
            </p:nvSpPr>
            <p:spPr>
              <a:xfrm>
                <a:off x="5942733" y="4086904"/>
                <a:ext cx="735103" cy="6208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4800" b="0" i="0" u="none" strike="noStrike" kern="0" cap="none" spc="0" normalizeH="0" baseline="0" noProof="0" dirty="0" err="1">
                    <a:ln>
                      <a:noFill/>
                    </a:ln>
                    <a:solidFill>
                      <a:sysClr val="windowText" lastClr="000000"/>
                    </a:solidFill>
                    <a:effectLst/>
                    <a:uLnTx/>
                    <a:uFillTx/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Athero</a:t>
                </a:r>
                <a:endParaRPr kumimoji="0" lang="en-US" sz="4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-TFs</a:t>
                </a:r>
                <a:endParaRPr kumimoji="0" lang="en-US" sz="4800" b="0" i="0" u="none" strike="noStrike" kern="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Tahoma" panose="020B0604030504040204" pitchFamily="34" charset="0"/>
                  <a:ea typeface="Tahoma" panose="020B0604030504040204" pitchFamily="34" charset="0"/>
                  <a:cs typeface="Tahoma" panose="020B0604030504040204" pitchFamily="34" charset="0"/>
                </a:endParaRPr>
              </a:p>
            </p:txBody>
          </p:sp>
        </p:grpSp>
        <p:grpSp>
          <p:nvGrpSpPr>
            <p:cNvPr id="193" name="그룹 192">
              <a:extLst>
                <a:ext uri="{FF2B5EF4-FFF2-40B4-BE49-F238E27FC236}">
                  <a16:creationId xmlns:a16="http://schemas.microsoft.com/office/drawing/2014/main" id="{674EA435-2F30-4D15-912D-01C5AC1DDF2E}"/>
                </a:ext>
              </a:extLst>
            </p:cNvPr>
            <p:cNvGrpSpPr/>
            <p:nvPr/>
          </p:nvGrpSpPr>
          <p:grpSpPr>
            <a:xfrm>
              <a:off x="11788478" y="28629752"/>
              <a:ext cx="3702707" cy="3567507"/>
              <a:chOff x="4495667" y="3723458"/>
              <a:chExt cx="1396371" cy="1361655"/>
            </a:xfrm>
          </p:grpSpPr>
          <p:sp>
            <p:nvSpPr>
              <p:cNvPr id="194" name="타원 193">
                <a:extLst>
                  <a:ext uri="{FF2B5EF4-FFF2-40B4-BE49-F238E27FC236}">
                    <a16:creationId xmlns:a16="http://schemas.microsoft.com/office/drawing/2014/main" id="{2F5B7E9F-E262-4CF4-BCBF-C663CFAC981E}"/>
                  </a:ext>
                </a:extLst>
              </p:cNvPr>
              <p:cNvSpPr/>
              <p:nvPr/>
            </p:nvSpPr>
            <p:spPr>
              <a:xfrm>
                <a:off x="4495667" y="3723458"/>
                <a:ext cx="1396371" cy="1361655"/>
              </a:xfrm>
              <a:prstGeom prst="ellipse">
                <a:avLst/>
              </a:prstGeom>
              <a:solidFill>
                <a:srgbClr val="7030A0">
                  <a:alpha val="30000"/>
                </a:srgbClr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4572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4800" b="0" i="0" u="none" strike="noStrike" kern="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</a:endParaRPr>
              </a:p>
            </p:txBody>
          </p:sp>
          <p:sp>
            <p:nvSpPr>
              <p:cNvPr id="195" name="직사각형 194">
                <a:extLst>
                  <a:ext uri="{FF2B5EF4-FFF2-40B4-BE49-F238E27FC236}">
                    <a16:creationId xmlns:a16="http://schemas.microsoft.com/office/drawing/2014/main" id="{1A89DF56-AD3B-4739-BBF6-33FE901A3737}"/>
                  </a:ext>
                </a:extLst>
              </p:cNvPr>
              <p:cNvSpPr/>
              <p:nvPr/>
            </p:nvSpPr>
            <p:spPr>
              <a:xfrm>
                <a:off x="4648980" y="4104668"/>
                <a:ext cx="690504" cy="6208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lvl="0" algn="ctr" defTabSz="457200">
                  <a:defRPr/>
                </a:pPr>
                <a:r>
                  <a:rPr lang="en-US" altLang="ko-KR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GWAS</a:t>
                </a:r>
              </a:p>
              <a:p>
                <a:pPr lvl="0" algn="ctr" defTabSz="457200">
                  <a:defRPr/>
                </a:pPr>
                <a:r>
                  <a:rPr lang="en-US" altLang="ko-KR" sz="4800" kern="0" dirty="0">
                    <a:solidFill>
                      <a:sysClr val="windowText" lastClr="000000"/>
                    </a:solidFill>
                    <a:latin typeface="Tahoma" panose="020B0604030504040204" pitchFamily="34" charset="0"/>
                    <a:ea typeface="Tahoma" panose="020B0604030504040204" pitchFamily="34" charset="0"/>
                    <a:cs typeface="Tahoma" panose="020B0604030504040204" pitchFamily="34" charset="0"/>
                  </a:rPr>
                  <a:t>-TFs</a:t>
                </a:r>
              </a:p>
            </p:txBody>
          </p:sp>
        </p:grpSp>
      </p:grpSp>
      <p:sp>
        <p:nvSpPr>
          <p:cNvPr id="198" name="TextBox 197">
            <a:extLst>
              <a:ext uri="{FF2B5EF4-FFF2-40B4-BE49-F238E27FC236}">
                <a16:creationId xmlns:a16="http://schemas.microsoft.com/office/drawing/2014/main" id="{29407FAF-9E13-47C0-82DE-A66AB1F3E246}"/>
              </a:ext>
            </a:extLst>
          </p:cNvPr>
          <p:cNvSpPr txBox="1"/>
          <p:nvPr/>
        </p:nvSpPr>
        <p:spPr>
          <a:xfrm>
            <a:off x="6858000" y="28858341"/>
            <a:ext cx="621593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4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Co-mapping analysis</a:t>
            </a:r>
            <a:endParaRPr kumimoji="0" lang="en-US" sz="4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</a:endParaRP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7CF9B00F-A61C-4B7E-AE3C-784037B02B2B}"/>
              </a:ext>
            </a:extLst>
          </p:cNvPr>
          <p:cNvSpPr txBox="1"/>
          <p:nvPr/>
        </p:nvSpPr>
        <p:spPr>
          <a:xfrm>
            <a:off x="17728858" y="28858341"/>
            <a:ext cx="7208515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1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4400" b="1" kern="0" dirty="0">
                <a:solidFill>
                  <a:prstClr val="black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Transcription factor (TF)  analysis</a:t>
            </a:r>
            <a:endParaRPr kumimoji="0" lang="en-US" sz="44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맑은 고딕"/>
            </a:endParaRPr>
          </a:p>
        </p:txBody>
      </p:sp>
      <p:sp>
        <p:nvSpPr>
          <p:cNvPr id="200" name="타원 199">
            <a:extLst>
              <a:ext uri="{FF2B5EF4-FFF2-40B4-BE49-F238E27FC236}">
                <a16:creationId xmlns:a16="http://schemas.microsoft.com/office/drawing/2014/main" id="{834056F6-47A5-4638-AB4F-A81A4C286B3E}"/>
              </a:ext>
            </a:extLst>
          </p:cNvPr>
          <p:cNvSpPr/>
          <p:nvPr/>
        </p:nvSpPr>
        <p:spPr>
          <a:xfrm>
            <a:off x="19468861" y="32221678"/>
            <a:ext cx="3708495" cy="3442817"/>
          </a:xfrm>
          <a:prstGeom prst="ellipse">
            <a:avLst/>
          </a:prstGeom>
          <a:solidFill>
            <a:srgbClr val="00B050">
              <a:alpha val="30000"/>
            </a:srgbClr>
          </a:solidFill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4800" b="0" i="0" u="none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  <p:sp>
        <p:nvSpPr>
          <p:cNvPr id="201" name="직사각형 200">
            <a:extLst>
              <a:ext uri="{FF2B5EF4-FFF2-40B4-BE49-F238E27FC236}">
                <a16:creationId xmlns:a16="http://schemas.microsoft.com/office/drawing/2014/main" id="{9A62D0D1-1B0A-47FD-9061-9F470A043B8D}"/>
              </a:ext>
            </a:extLst>
          </p:cNvPr>
          <p:cNvSpPr/>
          <p:nvPr/>
        </p:nvSpPr>
        <p:spPr>
          <a:xfrm>
            <a:off x="20518240" y="33857258"/>
            <a:ext cx="1609736" cy="156966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4800" b="0" i="0" u="none" strike="noStrike" kern="0" cap="none" spc="0" normalizeH="0" baseline="0" noProof="0" dirty="0" err="1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eQTL</a:t>
            </a:r>
            <a:endParaRPr lang="en-US" sz="4800" kern="0" dirty="0">
              <a:solidFill>
                <a:sysClr val="windowText" lastClr="000000"/>
              </a:solidFill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4800" kern="0" dirty="0">
                <a:solidFill>
                  <a:sysClr val="windowText" lastClr="000000"/>
                </a:solidFill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-TFs</a:t>
            </a:r>
            <a:endParaRPr kumimoji="0" lang="en-US" sz="4800" b="0" i="0" u="none" strike="noStrike" kern="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0961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2" y="-155100"/>
            <a:ext cx="7641484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0" b="1" dirty="0"/>
              <a:t>Figure S2</a:t>
            </a:r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096DF978-8C53-45B0-A1E7-B7857A6FCF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224286" y="21484801"/>
            <a:ext cx="14400000" cy="14400000"/>
          </a:xfrm>
          <a:prstGeom prst="rect">
            <a:avLst/>
          </a:prstGeom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D1F3221D-909E-42C6-B63F-AEBFF92BB5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41486" y="4348800"/>
            <a:ext cx="14400000" cy="144000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46F4AF2D-D3B5-49E0-9359-0E6DA862C8F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1486" y="21484801"/>
            <a:ext cx="14400000" cy="144000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BD454621-5688-4E41-8479-AD9B0CEB0F2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224286" y="4348800"/>
            <a:ext cx="14400000" cy="1440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D687DF0-7C52-4D8E-A76C-05691B05F528}"/>
              </a:ext>
            </a:extLst>
          </p:cNvPr>
          <p:cNvSpPr txBox="1"/>
          <p:nvPr/>
        </p:nvSpPr>
        <p:spPr>
          <a:xfrm>
            <a:off x="443348" y="3071242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F4032D-E51D-410E-B2DC-17F1E78DB06F}"/>
              </a:ext>
            </a:extLst>
          </p:cNvPr>
          <p:cNvSpPr txBox="1"/>
          <p:nvPr/>
        </p:nvSpPr>
        <p:spPr>
          <a:xfrm>
            <a:off x="15224286" y="3071242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AF7CC9E-DA71-48EE-A725-F7CBB55ED9BB}"/>
              </a:ext>
            </a:extLst>
          </p:cNvPr>
          <p:cNvSpPr txBox="1"/>
          <p:nvPr/>
        </p:nvSpPr>
        <p:spPr>
          <a:xfrm>
            <a:off x="441486" y="19331970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B0F7DBE-EA49-48FA-BA31-BC0740234FEF}"/>
              </a:ext>
            </a:extLst>
          </p:cNvPr>
          <p:cNvSpPr txBox="1"/>
          <p:nvPr/>
        </p:nvSpPr>
        <p:spPr>
          <a:xfrm>
            <a:off x="15222424" y="19331970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705390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963" y="3734892"/>
            <a:ext cx="2965497" cy="7391045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3820" y="3734892"/>
            <a:ext cx="10466458" cy="7391045"/>
          </a:xfrm>
          <a:prstGeom prst="rect">
            <a:avLst/>
          </a:prstGeom>
        </p:spPr>
      </p:pic>
      <p:pic>
        <p:nvPicPr>
          <p:cNvPr id="17" name="그림 1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762" y="27377709"/>
            <a:ext cx="2965698" cy="7391546"/>
          </a:xfrm>
          <a:prstGeom prst="rect">
            <a:avLst/>
          </a:prstGeom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2288" y="27377709"/>
            <a:ext cx="10467990" cy="7392126"/>
          </a:xfrm>
          <a:prstGeom prst="rect">
            <a:avLst/>
          </a:prstGeom>
        </p:spPr>
      </p:pic>
      <p:pic>
        <p:nvPicPr>
          <p:cNvPr id="19" name="그림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762" y="11615497"/>
            <a:ext cx="2965698" cy="7391546"/>
          </a:xfrm>
          <a:prstGeom prst="rect">
            <a:avLst/>
          </a:prstGeom>
        </p:spPr>
      </p:pic>
      <p:pic>
        <p:nvPicPr>
          <p:cNvPr id="20" name="그림 19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2288" y="11615497"/>
            <a:ext cx="10467990" cy="7392126"/>
          </a:xfrm>
          <a:prstGeom prst="rect">
            <a:avLst/>
          </a:prstGeom>
        </p:spPr>
      </p:pic>
      <p:pic>
        <p:nvPicPr>
          <p:cNvPr id="21" name="그림 20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762" y="19497764"/>
            <a:ext cx="2965698" cy="7391546"/>
          </a:xfrm>
          <a:prstGeom prst="rect">
            <a:avLst/>
          </a:prstGeom>
        </p:spPr>
      </p:pic>
      <p:pic>
        <p:nvPicPr>
          <p:cNvPr id="22" name="그림 21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92288" y="19496603"/>
            <a:ext cx="10467990" cy="7392126"/>
          </a:xfrm>
          <a:prstGeom prst="rect">
            <a:avLst/>
          </a:prstGeom>
        </p:spPr>
      </p:pic>
      <p:pic>
        <p:nvPicPr>
          <p:cNvPr id="23" name="그림 22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66638" y="3734892"/>
            <a:ext cx="11086200" cy="7390800"/>
          </a:xfrm>
          <a:prstGeom prst="rect">
            <a:avLst/>
          </a:prstGeom>
        </p:spPr>
      </p:pic>
      <p:pic>
        <p:nvPicPr>
          <p:cNvPr id="24" name="그림 23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65106" y="11616243"/>
            <a:ext cx="11086200" cy="7390800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65106" y="19497929"/>
            <a:ext cx="11086200" cy="7390800"/>
          </a:xfrm>
          <a:prstGeom prst="rect">
            <a:avLst/>
          </a:prstGeom>
        </p:spPr>
      </p:pic>
      <p:pic>
        <p:nvPicPr>
          <p:cNvPr id="26" name="그림 25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65106" y="27377709"/>
            <a:ext cx="11086200" cy="739080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2" y="-155100"/>
            <a:ext cx="7641484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0" b="1" dirty="0"/>
              <a:t>Figure S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A01F0A-69FA-4CFF-89E8-6756A467253C}"/>
              </a:ext>
            </a:extLst>
          </p:cNvPr>
          <p:cNvSpPr txBox="1"/>
          <p:nvPr/>
        </p:nvSpPr>
        <p:spPr>
          <a:xfrm>
            <a:off x="443348" y="3071242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694C4D6-3ED6-48A8-B649-2ADF7AB79183}"/>
              </a:ext>
            </a:extLst>
          </p:cNvPr>
          <p:cNvSpPr txBox="1"/>
          <p:nvPr/>
        </p:nvSpPr>
        <p:spPr>
          <a:xfrm>
            <a:off x="443348" y="11286231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B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FE98D26-ED87-415C-8716-CCBF0FF5D5A4}"/>
              </a:ext>
            </a:extLst>
          </p:cNvPr>
          <p:cNvSpPr txBox="1"/>
          <p:nvPr/>
        </p:nvSpPr>
        <p:spPr>
          <a:xfrm>
            <a:off x="443348" y="19162720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C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4BCC1CD-123F-408D-A653-2715BE95579D}"/>
              </a:ext>
            </a:extLst>
          </p:cNvPr>
          <p:cNvSpPr txBox="1"/>
          <p:nvPr/>
        </p:nvSpPr>
        <p:spPr>
          <a:xfrm>
            <a:off x="443348" y="27149109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9108242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>
            <a:extLst>
              <a:ext uri="{FF2B5EF4-FFF2-40B4-BE49-F238E27FC236}">
                <a16:creationId xmlns:a16="http://schemas.microsoft.com/office/drawing/2014/main" id="{31CF41AB-910A-4F4E-AE00-14BECCE20850}"/>
              </a:ext>
            </a:extLst>
          </p:cNvPr>
          <p:cNvGrpSpPr/>
          <p:nvPr/>
        </p:nvGrpSpPr>
        <p:grpSpPr>
          <a:xfrm>
            <a:off x="585225" y="25670681"/>
            <a:ext cx="14959575" cy="8791499"/>
            <a:chOff x="585225" y="25670681"/>
            <a:chExt cx="14959575" cy="8791499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29B39009-CC36-461E-A23D-27BD85F21E7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5093"/>
            <a:stretch/>
          </p:blipFill>
          <p:spPr>
            <a:xfrm>
              <a:off x="630282" y="25670681"/>
              <a:ext cx="14914518" cy="7260420"/>
            </a:xfrm>
            <a:prstGeom prst="rect">
              <a:avLst/>
            </a:prstGeom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8635A417-ACD9-45C4-900F-4F60EB39A9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5457" b="1650"/>
            <a:stretch/>
          </p:blipFill>
          <p:spPr>
            <a:xfrm>
              <a:off x="585225" y="33019999"/>
              <a:ext cx="14914518" cy="1442181"/>
            </a:xfrm>
            <a:prstGeom prst="rect">
              <a:avLst/>
            </a:prstGeom>
          </p:spPr>
        </p:pic>
        <p:pic>
          <p:nvPicPr>
            <p:cNvPr id="27" name="Picture 4">
              <a:extLst>
                <a:ext uri="{FF2B5EF4-FFF2-40B4-BE49-F238E27FC236}">
                  <a16:creationId xmlns:a16="http://schemas.microsoft.com/office/drawing/2014/main" id="{028D6D91-838D-48AC-A742-09DC31CBBC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921" t="60123" r="11667" b="34656"/>
            <a:stretch/>
          </p:blipFill>
          <p:spPr>
            <a:xfrm>
              <a:off x="2416836" y="26476133"/>
              <a:ext cx="11520000" cy="485304"/>
            </a:xfrm>
            <a:prstGeom prst="rect">
              <a:avLst/>
            </a:prstGeom>
          </p:spPr>
        </p:pic>
      </p:grpSp>
      <p:grpSp>
        <p:nvGrpSpPr>
          <p:cNvPr id="16" name="그룹 15">
            <a:extLst>
              <a:ext uri="{FF2B5EF4-FFF2-40B4-BE49-F238E27FC236}">
                <a16:creationId xmlns:a16="http://schemas.microsoft.com/office/drawing/2014/main" id="{E047B35C-B0ED-42E0-935C-AA5EBE8268D3}"/>
              </a:ext>
            </a:extLst>
          </p:cNvPr>
          <p:cNvGrpSpPr/>
          <p:nvPr/>
        </p:nvGrpSpPr>
        <p:grpSpPr>
          <a:xfrm>
            <a:off x="15723692" y="25657199"/>
            <a:ext cx="14872270" cy="8582000"/>
            <a:chOff x="15723692" y="25657199"/>
            <a:chExt cx="14872270" cy="8582000"/>
          </a:xfrm>
        </p:grpSpPr>
        <p:pic>
          <p:nvPicPr>
            <p:cNvPr id="13" name="그림 12">
              <a:extLst>
                <a:ext uri="{FF2B5EF4-FFF2-40B4-BE49-F238E27FC236}">
                  <a16:creationId xmlns:a16="http://schemas.microsoft.com/office/drawing/2014/main" id="{F4D63BFD-AA45-4592-9D1C-6EC114E41F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34902"/>
            <a:stretch/>
          </p:blipFill>
          <p:spPr>
            <a:xfrm>
              <a:off x="15723692" y="25657199"/>
              <a:ext cx="14872270" cy="7261200"/>
            </a:xfrm>
            <a:prstGeom prst="rect">
              <a:avLst/>
            </a:prstGeom>
          </p:spPr>
        </p:pic>
        <p:pic>
          <p:nvPicPr>
            <p:cNvPr id="26" name="그림 25">
              <a:extLst>
                <a:ext uri="{FF2B5EF4-FFF2-40B4-BE49-F238E27FC236}">
                  <a16:creationId xmlns:a16="http://schemas.microsoft.com/office/drawing/2014/main" id="{86166833-DBCA-4367-9A7E-C73C09F199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85003" b="3383"/>
            <a:stretch/>
          </p:blipFill>
          <p:spPr>
            <a:xfrm>
              <a:off x="15723692" y="32943800"/>
              <a:ext cx="14872270" cy="1295399"/>
            </a:xfrm>
            <a:prstGeom prst="rect">
              <a:avLst/>
            </a:prstGeom>
          </p:spPr>
        </p:pic>
        <p:pic>
          <p:nvPicPr>
            <p:cNvPr id="30" name="Picture 4">
              <a:extLst>
                <a:ext uri="{FF2B5EF4-FFF2-40B4-BE49-F238E27FC236}">
                  <a16:creationId xmlns:a16="http://schemas.microsoft.com/office/drawing/2014/main" id="{690BB8CE-5C30-40CA-884E-7063A38364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9921" t="60123" r="11667" b="34656"/>
            <a:stretch/>
          </p:blipFill>
          <p:spPr>
            <a:xfrm>
              <a:off x="17624654" y="26425213"/>
              <a:ext cx="11520000" cy="485304"/>
            </a:xfrm>
            <a:prstGeom prst="rect">
              <a:avLst/>
            </a:prstGeom>
          </p:spPr>
        </p:pic>
      </p:grpSp>
      <p:pic>
        <p:nvPicPr>
          <p:cNvPr id="29" name="그림 28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24362" y="15062320"/>
            <a:ext cx="14871600" cy="11153700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282" y="15002123"/>
            <a:ext cx="14871600" cy="111537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489B8DC-F68A-B949-B89D-7D73E4E86EFF}"/>
              </a:ext>
            </a:extLst>
          </p:cNvPr>
          <p:cNvSpPr txBox="1"/>
          <p:nvPr/>
        </p:nvSpPr>
        <p:spPr>
          <a:xfrm>
            <a:off x="425812" y="15255510"/>
            <a:ext cx="199102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C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15296688" y="15410866"/>
            <a:ext cx="199102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7188560" y="3270576"/>
            <a:ext cx="12392188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lasma triglyceride </a:t>
            </a:r>
            <a:r>
              <a:rPr lang="en-US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QTL </a:t>
            </a:r>
          </a:p>
          <a:p>
            <a:pPr algn="ctr"/>
            <a:r>
              <a:rPr lang="en-US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n </a:t>
            </a:r>
            <a:r>
              <a:rPr lang="en-US" altLang="ko-KR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 sex additive model (24 weeks)</a:t>
            </a:r>
            <a:endParaRPr lang="en-US" sz="4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889334" y="3270576"/>
            <a:ext cx="1230630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lasma triglyceride </a:t>
            </a:r>
            <a:r>
              <a:rPr lang="en-US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QTL </a:t>
            </a:r>
          </a:p>
          <a:p>
            <a:pPr algn="ctr"/>
            <a:r>
              <a:rPr lang="en-US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n </a:t>
            </a:r>
            <a:r>
              <a:rPr lang="en-US" altLang="ko-KR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fe</a:t>
            </a:r>
            <a:r>
              <a:rPr lang="en-US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male mice </a:t>
            </a:r>
            <a:r>
              <a:rPr lang="en-US" altLang="ko-KR" sz="4400" b="1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(24 weeks)</a:t>
            </a:r>
            <a:endParaRPr lang="en-US" sz="4400" b="1" dirty="0">
              <a:latin typeface="Tahoma" panose="020B0604030504040204" pitchFamily="34" charset="0"/>
              <a:ea typeface="Tahoma" panose="020B0604030504040204" pitchFamily="34" charset="0"/>
              <a:cs typeface="Tahoma" panose="020B060403050404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489B8DC-F68A-B949-B89D-7D73E4E86EFF}"/>
              </a:ext>
            </a:extLst>
          </p:cNvPr>
          <p:cNvSpPr txBox="1"/>
          <p:nvPr/>
        </p:nvSpPr>
        <p:spPr>
          <a:xfrm>
            <a:off x="443348" y="3071242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15567868" y="3067150"/>
            <a:ext cx="289197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0" y="-155100"/>
            <a:ext cx="20116800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0" b="1" dirty="0"/>
              <a:t>Figure </a:t>
            </a:r>
            <a:r>
              <a:rPr lang="en-US" altLang="ko-KR" sz="13600" b="1" dirty="0"/>
              <a:t>S4</a:t>
            </a:r>
            <a:endParaRPr lang="en-US" sz="13600" b="1" dirty="0"/>
          </a:p>
        </p:txBody>
      </p:sp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945"/>
          <a:stretch/>
        </p:blipFill>
        <p:spPr>
          <a:xfrm>
            <a:off x="1076682" y="5096362"/>
            <a:ext cx="14425200" cy="9526525"/>
          </a:xfrm>
          <a:prstGeom prst="rect">
            <a:avLst/>
          </a:prstGeom>
        </p:spPr>
      </p:pic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127"/>
          <a:stretch/>
        </p:blipFill>
        <p:spPr>
          <a:xfrm>
            <a:off x="15947562" y="5096118"/>
            <a:ext cx="14425200" cy="950689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ADFE543C-210D-4798-9EF4-2F01ACE9A9AF}"/>
              </a:ext>
            </a:extLst>
          </p:cNvPr>
          <p:cNvSpPr txBox="1"/>
          <p:nvPr/>
        </p:nvSpPr>
        <p:spPr>
          <a:xfrm>
            <a:off x="425812" y="26349013"/>
            <a:ext cx="199102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FB7D93F-A93D-4D2F-9227-983FDFC8C9F2}"/>
              </a:ext>
            </a:extLst>
          </p:cNvPr>
          <p:cNvSpPr txBox="1"/>
          <p:nvPr/>
        </p:nvSpPr>
        <p:spPr>
          <a:xfrm>
            <a:off x="15296688" y="26504369"/>
            <a:ext cx="199102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600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6336568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0E0878C3-39E6-C046-B8B7-58499997A398}"/>
              </a:ext>
            </a:extLst>
          </p:cNvPr>
          <p:cNvSpPr txBox="1"/>
          <p:nvPr/>
        </p:nvSpPr>
        <p:spPr>
          <a:xfrm>
            <a:off x="0" y="-155100"/>
            <a:ext cx="20116800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600" b="1" dirty="0"/>
              <a:t>Figure </a:t>
            </a:r>
            <a:r>
              <a:rPr lang="en-US" altLang="ko-KR" sz="13600" b="1" dirty="0"/>
              <a:t>S5</a:t>
            </a:r>
            <a:endParaRPr lang="en-US" sz="13600" b="1" dirty="0"/>
          </a:p>
        </p:txBody>
      </p:sp>
      <p:pic>
        <p:nvPicPr>
          <p:cNvPr id="3" name="그림 2">
            <a:extLst>
              <a:ext uri="{FF2B5EF4-FFF2-40B4-BE49-F238E27FC236}">
                <a16:creationId xmlns:a16="http://schemas.microsoft.com/office/drawing/2014/main" id="{23B3C570-887F-4173-BD75-0D5B6FA6A29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55158" y="3233922"/>
            <a:ext cx="27453342" cy="2402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8228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17C484C555879B479210D70BCD9CF460" ma:contentTypeVersion="8" ma:contentTypeDescription="Create a new document." ma:contentTypeScope="" ma:versionID="3497e892779ccf86afbabbb6c9d2cc0e">
  <xsd:schema xmlns:xsd="http://www.w3.org/2001/XMLSchema" xmlns:xs="http://www.w3.org/2001/XMLSchema" xmlns:p="http://schemas.microsoft.com/office/2006/metadata/properties" xmlns:ns2="c53ed5bc-5ed8-45d1-bc7a-6aeb5d9d48ab" targetNamespace="http://schemas.microsoft.com/office/2006/metadata/properties" ma:root="true" ma:fieldsID="1795f2d6d81657eec2c98e88a81339e3" ns2:_="">
    <xsd:import namespace="c53ed5bc-5ed8-45d1-bc7a-6aeb5d9d48a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53ed5bc-5ed8-45d1-bc7a-6aeb5d9d48a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9A2B692C-F80E-4D7E-8568-D23591BBE45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c53ed5bc-5ed8-45d1-bc7a-6aeb5d9d48a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6B9F058-9D85-43B2-BDEA-E70127ACD0D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C8422A2D-831F-4EF5-B4C2-5FCEDE539117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5278</TotalTime>
  <Words>206</Words>
  <Application>Microsoft Office PowerPoint</Application>
  <PresentationFormat>사용자 지정</PresentationFormat>
  <Paragraphs>79</Paragraphs>
  <Slides>5</Slides>
  <Notes>4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11" baseType="lpstr">
      <vt:lpstr>맑은 고딕</vt:lpstr>
      <vt:lpstr>Arial</vt:lpstr>
      <vt:lpstr>Calibri</vt:lpstr>
      <vt:lpstr>Calibri Light</vt:lpstr>
      <vt:lpstr>Tahoma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oebe Yam</dc:creator>
  <cp:lastModifiedBy>Myungsuk Kim</cp:lastModifiedBy>
  <cp:revision>520</cp:revision>
  <dcterms:created xsi:type="dcterms:W3CDTF">2020-04-28T19:33:49Z</dcterms:created>
  <dcterms:modified xsi:type="dcterms:W3CDTF">2023-02-22T00:51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17C484C555879B479210D70BCD9CF460</vt:lpwstr>
  </property>
</Properties>
</file>